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1836EB-E99E-BC72-52E3-7C00C4D5BD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102C70E-73CE-240D-81E8-45EBC34C51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5FC5D0-A115-EAD8-9EDD-B5FE74331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52AA7B-1F51-C7F3-0433-1D955979D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A4736D-EB6A-4D54-8EC0-D0B316A311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382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8B0777-B6E8-CB58-CF5E-CE523F699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E984F6-120F-2774-8D4A-111B5F3351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BCCF8E-B37D-219E-7D04-B29FBBCB1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987FA6-F9E3-CD08-C754-0D4E58E4C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B2CC6F-F866-09E7-90B7-43D0F1792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543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EBF5557-949B-F67C-F685-A4BD8781A5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683E37F-C095-0F7A-11E9-77CE64ECEF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C7ABCA-482C-52D1-F27C-03F0D5F55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968718-B3FC-D226-99B4-1F4073D91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5F0C0B-27F4-4868-CFA3-2AB6FAF38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39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5C1089-4887-178E-8B99-4DA4D34332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DB6AA5-4FCB-ABDB-8542-905AD799FD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8AF0FB-BAA5-1022-000B-00AE40DF8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A5F185-9B84-C6DB-FD78-72548E2F3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BD3E2F-B05C-3889-7322-A48C07D70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034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9626DF-F275-B299-EC95-A65CD6CA13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78274A-B26D-1FA8-7224-7466455A9B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058924-9816-A415-EA34-0D918A6A9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AEB706-5120-6E41-5621-6F6BAC6E2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A5EE37-B632-DB2F-F917-A96216DB5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4293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990733-472C-A978-2F8F-B75017FCB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E6342D6-444D-0DE1-E4B7-D55D03439F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6F5B5C3-A9A3-5CB1-9995-CAF8D959B9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05C3D2-7734-8CA0-7F68-8C67292A2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7504E61-0828-444B-760C-D2D00EC57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947BA73-8165-007E-4973-2DC721455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615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CAB698-7551-ED1D-297F-0ABA2C03E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ECF5FCB-9F3E-FBCB-E139-A9D77945B8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28B982A-D283-93D5-BA40-0D292748B6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A1D9969-0A95-8779-6CF7-5E4BE1F405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339BA38-A8A4-79E6-BBAA-28630D8D6B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84B4EFD-AFF2-A50B-EBAA-93C1A597E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78B3710-1B15-2142-283B-4DE99CB64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7B8DE83-0F1A-2E4A-9E19-9BB04E908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429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EEBE62-86C6-248C-8D64-D6E08DD12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93C41B5-C959-76EB-72E1-40E2A95BB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C12E8FD-D392-80B2-0100-9384F517A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903E8B6-7D21-A145-BD21-58C4C6A5A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8472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344501-5015-BE0D-BEFE-AAA30EC71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E7247FF-D177-94E6-BA2A-B84BFCEB6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1A1E214-B6A6-978E-614B-9EC2DBD8A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921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51E819-0D12-1F93-1B60-562212F2B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018DB75-9D54-85D3-0CA8-EA5452644D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505A3E8-0927-FC8C-505C-C70E8A19E0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E0552F-7CFD-CB73-5A95-D45F49FF4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6F499D7-9956-5B72-4CAD-3D4669536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651F25-22C6-7DCB-4404-87D648873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2492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3A32D1-BA49-8E13-D70F-4518EDA1A0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BF4E0C3-555C-DA17-8894-CB79550CC5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047A73D-AC13-9696-3247-240381F2A7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60CB339-8B15-A62C-4BE7-184389F0A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FF92DD-8CC9-51F9-8AEA-FA625D99C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11B392A-8B8B-79CC-B1E8-7675404B8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48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D5A826B-B96A-D8B6-A3B0-ABE85BF78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1772D6E-02B1-3D7E-F757-4C2CFCACEC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F59CFA-B73B-4F3A-5144-4DF2EEDD75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995FE-001B-7144-93B8-871F2A99F355}" type="datetimeFigureOut">
              <a:rPr kumimoji="1" lang="ja-JP" altLang="en-US" smtClean="0"/>
              <a:t>2024/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4BA2BA-29DA-177D-CED2-D373792F0D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837487-2812-9129-8899-AC48A8CEF7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121049-56C5-354C-A2E9-F09AFC7D1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742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39F471A-4ADD-C08E-F217-B2E36CBC9BB9}"/>
              </a:ext>
            </a:extLst>
          </p:cNvPr>
          <p:cNvSpPr txBox="1"/>
          <p:nvPr/>
        </p:nvSpPr>
        <p:spPr>
          <a:xfrm>
            <a:off x="2533229" y="232976"/>
            <a:ext cx="60258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ec</a:t>
            </a:r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nic supporting information: Video S1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6200647.AVI">
            <a:hlinkClick r:id="" action="ppaction://media"/>
            <a:extLst>
              <a:ext uri="{FF2B5EF4-FFF2-40B4-BE49-F238E27FC236}">
                <a16:creationId xmlns:a16="http://schemas.microsoft.com/office/drawing/2014/main" id="{F8D63EC9-E38C-C7D1-7FF0-B239C9D4C16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10878" y="1451160"/>
            <a:ext cx="4175093" cy="3131320"/>
          </a:xfrm>
          <a:prstGeom prst="rect">
            <a:avLst/>
          </a:prstGeom>
        </p:spPr>
      </p:pic>
      <p:sp>
        <p:nvSpPr>
          <p:cNvPr id="6" name="テキスト ボックス 6">
            <a:extLst>
              <a:ext uri="{FF2B5EF4-FFF2-40B4-BE49-F238E27FC236}">
                <a16:creationId xmlns:a16="http://schemas.microsoft.com/office/drawing/2014/main" id="{FBB7EF77-B9BD-D7FF-212B-74A4BE5854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4470" y="800367"/>
            <a:ext cx="97113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morphous blue phase III exhibiting high-contrast, hysteresis-free, and wide-viewing angle switching.</a:t>
            </a:r>
            <a:r>
              <a:rPr lang="ja-JP" altLang="ja-JP" sz="1400">
                <a:effectLst/>
              </a:rPr>
              <a:t> </a:t>
            </a:r>
            <a:endParaRPr lang="ja-JP" altLang="en-US" sz="1800"/>
          </a:p>
        </p:txBody>
      </p:sp>
      <p:grpSp>
        <p:nvGrpSpPr>
          <p:cNvPr id="8" name="グループ化 27">
            <a:extLst>
              <a:ext uri="{FF2B5EF4-FFF2-40B4-BE49-F238E27FC236}">
                <a16:creationId xmlns:a16="http://schemas.microsoft.com/office/drawing/2014/main" id="{2FD6848B-3734-D4CB-AAD8-84CE8689055D}"/>
              </a:ext>
            </a:extLst>
          </p:cNvPr>
          <p:cNvGrpSpPr>
            <a:grpSpLocks/>
          </p:cNvGrpSpPr>
          <p:nvPr/>
        </p:nvGrpSpPr>
        <p:grpSpPr bwMode="auto">
          <a:xfrm>
            <a:off x="2434598" y="5033384"/>
            <a:ext cx="5927652" cy="1188741"/>
            <a:chOff x="1593196" y="4673526"/>
            <a:chExt cx="6149423" cy="1255677"/>
          </a:xfrm>
        </p:grpSpPr>
        <p:grpSp>
          <p:nvGrpSpPr>
            <p:cNvPr id="9" name="グループ化 190">
              <a:extLst>
                <a:ext uri="{FF2B5EF4-FFF2-40B4-BE49-F238E27FC236}">
                  <a16:creationId xmlns:a16="http://schemas.microsoft.com/office/drawing/2014/main" id="{E1A3371A-7EA5-9FAF-C47A-575D6BAD2E7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977726" y="4828818"/>
              <a:ext cx="1313152" cy="989596"/>
              <a:chOff x="3335516" y="4256572"/>
              <a:chExt cx="1909599" cy="1505015"/>
            </a:xfrm>
          </p:grpSpPr>
          <p:sp>
            <p:nvSpPr>
              <p:cNvPr id="125" name="円/楕円 124">
                <a:extLst>
                  <a:ext uri="{FF2B5EF4-FFF2-40B4-BE49-F238E27FC236}">
                    <a16:creationId xmlns:a16="http://schemas.microsoft.com/office/drawing/2014/main" id="{FB735F80-E943-24BA-A0FB-83139EFF2E1C}"/>
                  </a:ext>
                </a:extLst>
              </p:cNvPr>
              <p:cNvSpPr/>
              <p:nvPr/>
            </p:nvSpPr>
            <p:spPr bwMode="auto">
              <a:xfrm rot="5400000">
                <a:off x="3454697" y="4832224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26" name="円/楕円 125">
                <a:extLst>
                  <a:ext uri="{FF2B5EF4-FFF2-40B4-BE49-F238E27FC236}">
                    <a16:creationId xmlns:a16="http://schemas.microsoft.com/office/drawing/2014/main" id="{0F5B1E2F-F027-984F-05E7-3AD3DFB76392}"/>
                  </a:ext>
                </a:extLst>
              </p:cNvPr>
              <p:cNvSpPr/>
              <p:nvPr/>
            </p:nvSpPr>
            <p:spPr bwMode="auto">
              <a:xfrm rot="5400000">
                <a:off x="4300313" y="5539080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27" name="円/楕円 126">
                <a:extLst>
                  <a:ext uri="{FF2B5EF4-FFF2-40B4-BE49-F238E27FC236}">
                    <a16:creationId xmlns:a16="http://schemas.microsoft.com/office/drawing/2014/main" id="{85516D73-4237-BF6B-CFCD-30E2885A8FD0}"/>
                  </a:ext>
                </a:extLst>
              </p:cNvPr>
              <p:cNvSpPr/>
              <p:nvPr/>
            </p:nvSpPr>
            <p:spPr bwMode="auto">
              <a:xfrm rot="5400000">
                <a:off x="4653931" y="4427592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28" name="円/楕円 127">
                <a:extLst>
                  <a:ext uri="{FF2B5EF4-FFF2-40B4-BE49-F238E27FC236}">
                    <a16:creationId xmlns:a16="http://schemas.microsoft.com/office/drawing/2014/main" id="{374716CB-0134-A107-67A7-F2E2D6F57E81}"/>
                  </a:ext>
                </a:extLst>
              </p:cNvPr>
              <p:cNvSpPr/>
              <p:nvPr/>
            </p:nvSpPr>
            <p:spPr bwMode="auto">
              <a:xfrm rot="5400000">
                <a:off x="4121520" y="4207443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29" name="円/楕円 128">
                <a:extLst>
                  <a:ext uri="{FF2B5EF4-FFF2-40B4-BE49-F238E27FC236}">
                    <a16:creationId xmlns:a16="http://schemas.microsoft.com/office/drawing/2014/main" id="{2B8C8E2F-3230-189A-5A8B-8473166E255B}"/>
                  </a:ext>
                </a:extLst>
              </p:cNvPr>
              <p:cNvSpPr/>
              <p:nvPr/>
            </p:nvSpPr>
            <p:spPr bwMode="auto">
              <a:xfrm rot="5400000">
                <a:off x="4618026" y="5194051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0" name="円/楕円 129">
                <a:extLst>
                  <a:ext uri="{FF2B5EF4-FFF2-40B4-BE49-F238E27FC236}">
                    <a16:creationId xmlns:a16="http://schemas.microsoft.com/office/drawing/2014/main" id="{673BEE10-BC2A-409F-CBBB-B99745257F2C}"/>
                  </a:ext>
                </a:extLst>
              </p:cNvPr>
              <p:cNvSpPr/>
              <p:nvPr/>
            </p:nvSpPr>
            <p:spPr bwMode="auto">
              <a:xfrm rot="5400000">
                <a:off x="4573623" y="4189054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1" name="円/楕円 130">
                <a:extLst>
                  <a:ext uri="{FF2B5EF4-FFF2-40B4-BE49-F238E27FC236}">
                    <a16:creationId xmlns:a16="http://schemas.microsoft.com/office/drawing/2014/main" id="{993C6D42-36A7-4DC4-1877-8D9A07A928D2}"/>
                  </a:ext>
                </a:extLst>
              </p:cNvPr>
              <p:cNvSpPr/>
              <p:nvPr/>
            </p:nvSpPr>
            <p:spPr bwMode="auto">
              <a:xfrm rot="5400000">
                <a:off x="3958687" y="4832224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2" name="円/楕円 131">
                <a:extLst>
                  <a:ext uri="{FF2B5EF4-FFF2-40B4-BE49-F238E27FC236}">
                    <a16:creationId xmlns:a16="http://schemas.microsoft.com/office/drawing/2014/main" id="{50693F19-244C-4494-4490-2525311BD572}"/>
                  </a:ext>
                </a:extLst>
              </p:cNvPr>
              <p:cNvSpPr/>
              <p:nvPr/>
            </p:nvSpPr>
            <p:spPr bwMode="auto">
              <a:xfrm rot="5400000">
                <a:off x="4054718" y="4595042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3" name="円/楕円 132">
                <a:extLst>
                  <a:ext uri="{FF2B5EF4-FFF2-40B4-BE49-F238E27FC236}">
                    <a16:creationId xmlns:a16="http://schemas.microsoft.com/office/drawing/2014/main" id="{C4BDF774-9285-8209-0218-235A0748F4D6}"/>
                  </a:ext>
                </a:extLst>
              </p:cNvPr>
              <p:cNvSpPr/>
              <p:nvPr/>
            </p:nvSpPr>
            <p:spPr bwMode="auto">
              <a:xfrm rot="5400000">
                <a:off x="3719767" y="5091119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4" name="円/楕円 133">
                <a:extLst>
                  <a:ext uri="{FF2B5EF4-FFF2-40B4-BE49-F238E27FC236}">
                    <a16:creationId xmlns:a16="http://schemas.microsoft.com/office/drawing/2014/main" id="{B48B1123-48E1-F8D6-47A8-13FA924F474C}"/>
                  </a:ext>
                </a:extLst>
              </p:cNvPr>
              <p:cNvSpPr/>
              <p:nvPr/>
            </p:nvSpPr>
            <p:spPr bwMode="auto">
              <a:xfrm rot="5400000">
                <a:off x="3536362" y="5370059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5" name="円/楕円 134">
                <a:extLst>
                  <a:ext uri="{FF2B5EF4-FFF2-40B4-BE49-F238E27FC236}">
                    <a16:creationId xmlns:a16="http://schemas.microsoft.com/office/drawing/2014/main" id="{238FEAD9-8F2D-7B1A-9262-00761D9F8422}"/>
                  </a:ext>
                </a:extLst>
              </p:cNvPr>
              <p:cNvSpPr/>
              <p:nvPr/>
            </p:nvSpPr>
            <p:spPr bwMode="auto">
              <a:xfrm rot="5400000">
                <a:off x="3606213" y="4352291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6" name="円/楕円 135">
                <a:extLst>
                  <a:ext uri="{FF2B5EF4-FFF2-40B4-BE49-F238E27FC236}">
                    <a16:creationId xmlns:a16="http://schemas.microsoft.com/office/drawing/2014/main" id="{A71A79B6-273D-FB9F-859B-E9523D254BD3}"/>
                  </a:ext>
                </a:extLst>
              </p:cNvPr>
              <p:cNvSpPr/>
              <p:nvPr/>
            </p:nvSpPr>
            <p:spPr bwMode="auto">
              <a:xfrm rot="5400000">
                <a:off x="4198872" y="5221985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7" name="円/楕円 136">
                <a:extLst>
                  <a:ext uri="{FF2B5EF4-FFF2-40B4-BE49-F238E27FC236}">
                    <a16:creationId xmlns:a16="http://schemas.microsoft.com/office/drawing/2014/main" id="{91758BF9-3FED-E083-D41E-A428301E94FB}"/>
                  </a:ext>
                </a:extLst>
              </p:cNvPr>
              <p:cNvSpPr/>
              <p:nvPr/>
            </p:nvSpPr>
            <p:spPr bwMode="auto">
              <a:xfrm rot="5400000">
                <a:off x="5022608" y="4586657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8" name="円/楕円 137">
                <a:extLst>
                  <a:ext uri="{FF2B5EF4-FFF2-40B4-BE49-F238E27FC236}">
                    <a16:creationId xmlns:a16="http://schemas.microsoft.com/office/drawing/2014/main" id="{FD657F70-6E35-0AB2-F06B-6591832E675E}"/>
                  </a:ext>
                </a:extLst>
              </p:cNvPr>
              <p:cNvSpPr/>
              <p:nvPr/>
            </p:nvSpPr>
            <p:spPr bwMode="auto">
              <a:xfrm rot="5400000">
                <a:off x="4851764" y="4892576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39" name="円/楕円 138">
                <a:extLst>
                  <a:ext uri="{FF2B5EF4-FFF2-40B4-BE49-F238E27FC236}">
                    <a16:creationId xmlns:a16="http://schemas.microsoft.com/office/drawing/2014/main" id="{76858780-F2F8-2674-7D43-D4B44519739E}"/>
                  </a:ext>
                </a:extLst>
              </p:cNvPr>
              <p:cNvSpPr/>
              <p:nvPr/>
            </p:nvSpPr>
            <p:spPr bwMode="auto">
              <a:xfrm rot="5400000">
                <a:off x="4390896" y="4706881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40" name="円/楕円 139">
                <a:extLst>
                  <a:ext uri="{FF2B5EF4-FFF2-40B4-BE49-F238E27FC236}">
                    <a16:creationId xmlns:a16="http://schemas.microsoft.com/office/drawing/2014/main" id="{E8C884F7-61CD-A5AD-A3A1-025B79850C32}"/>
                  </a:ext>
                </a:extLst>
              </p:cNvPr>
              <p:cNvSpPr/>
              <p:nvPr/>
            </p:nvSpPr>
            <p:spPr bwMode="auto">
              <a:xfrm rot="5400000">
                <a:off x="3720793" y="4137391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41" name="円/楕円 140">
                <a:extLst>
                  <a:ext uri="{FF2B5EF4-FFF2-40B4-BE49-F238E27FC236}">
                    <a16:creationId xmlns:a16="http://schemas.microsoft.com/office/drawing/2014/main" id="{37F7DAEB-8B45-5891-3546-944E6FFE69E9}"/>
                  </a:ext>
                </a:extLst>
              </p:cNvPr>
              <p:cNvSpPr/>
              <p:nvPr/>
            </p:nvSpPr>
            <p:spPr bwMode="auto">
              <a:xfrm rot="5400000">
                <a:off x="4870987" y="5399546"/>
                <a:ext cx="103326" cy="341688"/>
              </a:xfrm>
              <a:prstGeom prst="ellipse">
                <a:avLst/>
              </a:prstGeom>
              <a:gradFill flip="none" rotWithShape="1">
                <a:gsLst>
                  <a:gs pos="100000">
                    <a:srgbClr val="3333FF"/>
                  </a:gs>
                  <a:gs pos="31000">
                    <a:srgbClr val="C2D1ED"/>
                  </a:gs>
                  <a:gs pos="0">
                    <a:srgbClr val="E1E8F5"/>
                  </a:gs>
                </a:gsLst>
                <a:path path="circle">
                  <a:fillToRect l="50000" t="50000" r="50000" b="50000"/>
                </a:path>
                <a:tileRect/>
              </a:gra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</p:grpSp>
        <p:grpSp>
          <p:nvGrpSpPr>
            <p:cNvPr id="10" name="グループ化 20">
              <a:extLst>
                <a:ext uri="{FF2B5EF4-FFF2-40B4-BE49-F238E27FC236}">
                  <a16:creationId xmlns:a16="http://schemas.microsoft.com/office/drawing/2014/main" id="{9781359F-5156-AD08-053C-4E4747AEA82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593196" y="4675934"/>
              <a:ext cx="1292892" cy="1253269"/>
              <a:chOff x="1457251" y="4742284"/>
              <a:chExt cx="1436768" cy="1105269"/>
            </a:xfrm>
          </p:grpSpPr>
          <p:grpSp>
            <p:nvGrpSpPr>
              <p:cNvPr id="68" name="グループ化 210">
                <a:extLst>
                  <a:ext uri="{FF2B5EF4-FFF2-40B4-BE49-F238E27FC236}">
                    <a16:creationId xmlns:a16="http://schemas.microsoft.com/office/drawing/2014/main" id="{57223C12-74E3-6F6F-2FCF-ECE1E469977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845225">
                <a:off x="1595865" y="4886764"/>
                <a:ext cx="1298154" cy="384587"/>
                <a:chOff x="6724796" y="3642069"/>
                <a:chExt cx="1165412" cy="573742"/>
              </a:xfrm>
            </p:grpSpPr>
            <p:sp>
              <p:nvSpPr>
                <p:cNvPr id="123" name="フリーフォーム 258">
                  <a:extLst>
                    <a:ext uri="{FF2B5EF4-FFF2-40B4-BE49-F238E27FC236}">
                      <a16:creationId xmlns:a16="http://schemas.microsoft.com/office/drawing/2014/main" id="{52EF89DF-D963-4F46-06B6-15E98A313A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24796" y="3642070"/>
                  <a:ext cx="1165412" cy="573741"/>
                </a:xfrm>
                <a:custGeom>
                  <a:avLst/>
                  <a:gdLst>
                    <a:gd name="T0" fmla="*/ 0 w 1165412"/>
                    <a:gd name="T1" fmla="*/ 573741 h 573741"/>
                    <a:gd name="T2" fmla="*/ 277906 w 1165412"/>
                    <a:gd name="T3" fmla="*/ 277906 h 573741"/>
                    <a:gd name="T4" fmla="*/ 528918 w 1165412"/>
                    <a:gd name="T5" fmla="*/ 233082 h 573741"/>
                    <a:gd name="T6" fmla="*/ 968189 w 1165412"/>
                    <a:gd name="T7" fmla="*/ 152400 h 573741"/>
                    <a:gd name="T8" fmla="*/ 1165412 w 1165412"/>
                    <a:gd name="T9" fmla="*/ 0 h 573741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24" name="フリーフォーム 123">
                  <a:extLst>
                    <a:ext uri="{FF2B5EF4-FFF2-40B4-BE49-F238E27FC236}">
                      <a16:creationId xmlns:a16="http://schemas.microsoft.com/office/drawing/2014/main" id="{C8059AA6-381D-BB67-9C2E-D4CFB343B61F}"/>
                    </a:ext>
                  </a:extLst>
                </p:cNvPr>
                <p:cNvSpPr/>
                <p:nvPr/>
              </p:nvSpPr>
              <p:spPr bwMode="auto">
                <a:xfrm>
                  <a:off x="6724796" y="3642069"/>
                  <a:ext cx="1165412" cy="573741"/>
                </a:xfrm>
                <a:custGeom>
                  <a:avLst/>
                  <a:gdLst>
                    <a:gd name="connsiteX0" fmla="*/ 0 w 1165412"/>
                    <a:gd name="connsiteY0" fmla="*/ 573741 h 573741"/>
                    <a:gd name="connsiteX1" fmla="*/ 277906 w 1165412"/>
                    <a:gd name="connsiteY1" fmla="*/ 277906 h 573741"/>
                    <a:gd name="connsiteX2" fmla="*/ 528918 w 1165412"/>
                    <a:gd name="connsiteY2" fmla="*/ 233082 h 573741"/>
                    <a:gd name="connsiteX3" fmla="*/ 968189 w 1165412"/>
                    <a:gd name="connsiteY3" fmla="*/ 152400 h 573741"/>
                    <a:gd name="connsiteX4" fmla="*/ 1165412 w 1165412"/>
                    <a:gd name="connsiteY4" fmla="*/ 0 h 573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3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69" name="グループ化 212">
                <a:extLst>
                  <a:ext uri="{FF2B5EF4-FFF2-40B4-BE49-F238E27FC236}">
                    <a16:creationId xmlns:a16="http://schemas.microsoft.com/office/drawing/2014/main" id="{B3C53C35-F34B-BB0E-99CE-6C1A2848BAB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586411" y="4795449"/>
                <a:ext cx="370691" cy="877336"/>
                <a:chOff x="8189975" y="1357391"/>
                <a:chExt cx="404371" cy="1308847"/>
              </a:xfrm>
            </p:grpSpPr>
            <p:sp>
              <p:nvSpPr>
                <p:cNvPr id="121" name="フリーフォーム 255">
                  <a:extLst>
                    <a:ext uri="{FF2B5EF4-FFF2-40B4-BE49-F238E27FC236}">
                      <a16:creationId xmlns:a16="http://schemas.microsoft.com/office/drawing/2014/main" id="{9D2B0512-F6FC-C27D-9F69-CD67280BF0B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189975" y="1357391"/>
                  <a:ext cx="404371" cy="1308847"/>
                </a:xfrm>
                <a:custGeom>
                  <a:avLst/>
                  <a:gdLst>
                    <a:gd name="T0" fmla="*/ 44824 w 404371"/>
                    <a:gd name="T1" fmla="*/ 0 h 1308847"/>
                    <a:gd name="T2" fmla="*/ 313765 w 404371"/>
                    <a:gd name="T3" fmla="*/ 394447 h 1308847"/>
                    <a:gd name="T4" fmla="*/ 403412 w 404371"/>
                    <a:gd name="T5" fmla="*/ 681318 h 1308847"/>
                    <a:gd name="T6" fmla="*/ 349624 w 404371"/>
                    <a:gd name="T7" fmla="*/ 914400 h 1308847"/>
                    <a:gd name="T8" fmla="*/ 179294 w 404371"/>
                    <a:gd name="T9" fmla="*/ 1066800 h 1308847"/>
                    <a:gd name="T10" fmla="*/ 0 w 404371"/>
                    <a:gd name="T11" fmla="*/ 1308847 h 1308847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0" t="0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22" name="フリーフォーム 121">
                  <a:extLst>
                    <a:ext uri="{FF2B5EF4-FFF2-40B4-BE49-F238E27FC236}">
                      <a16:creationId xmlns:a16="http://schemas.microsoft.com/office/drawing/2014/main" id="{E5DE1FC4-68DF-DD08-4325-F05C9BAF6AEC}"/>
                    </a:ext>
                  </a:extLst>
                </p:cNvPr>
                <p:cNvSpPr/>
                <p:nvPr/>
              </p:nvSpPr>
              <p:spPr bwMode="auto">
                <a:xfrm>
                  <a:off x="8189975" y="1357391"/>
                  <a:ext cx="404371" cy="1308847"/>
                </a:xfrm>
                <a:custGeom>
                  <a:avLst/>
                  <a:gdLst>
                    <a:gd name="connsiteX0" fmla="*/ 44824 w 404371"/>
                    <a:gd name="connsiteY0" fmla="*/ 0 h 1308847"/>
                    <a:gd name="connsiteX1" fmla="*/ 313765 w 404371"/>
                    <a:gd name="connsiteY1" fmla="*/ 394447 h 1308847"/>
                    <a:gd name="connsiteX2" fmla="*/ 403412 w 404371"/>
                    <a:gd name="connsiteY2" fmla="*/ 681318 h 1308847"/>
                    <a:gd name="connsiteX3" fmla="*/ 349624 w 404371"/>
                    <a:gd name="connsiteY3" fmla="*/ 914400 h 1308847"/>
                    <a:gd name="connsiteX4" fmla="*/ 179294 w 404371"/>
                    <a:gd name="connsiteY4" fmla="*/ 1066800 h 1308847"/>
                    <a:gd name="connsiteX5" fmla="*/ 0 w 404371"/>
                    <a:gd name="connsiteY5" fmla="*/ 1308847 h 130884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70" name="グループ化 229">
                <a:extLst>
                  <a:ext uri="{FF2B5EF4-FFF2-40B4-BE49-F238E27FC236}">
                    <a16:creationId xmlns:a16="http://schemas.microsoft.com/office/drawing/2014/main" id="{85CB99E9-B472-302A-290F-3FC18D6BA46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10503058">
                <a:off x="2470346" y="4911972"/>
                <a:ext cx="392389" cy="896185"/>
                <a:chOff x="5350165" y="1120588"/>
                <a:chExt cx="428041" cy="1336966"/>
              </a:xfrm>
            </p:grpSpPr>
            <p:sp>
              <p:nvSpPr>
                <p:cNvPr id="119" name="フリーフォーム 253">
                  <a:extLst>
                    <a:ext uri="{FF2B5EF4-FFF2-40B4-BE49-F238E27FC236}">
                      <a16:creationId xmlns:a16="http://schemas.microsoft.com/office/drawing/2014/main" id="{90E412AB-0A4B-7956-46B8-62594470FF0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0165" y="1120588"/>
                  <a:ext cx="423732" cy="1335741"/>
                </a:xfrm>
                <a:custGeom>
                  <a:avLst/>
                  <a:gdLst>
                    <a:gd name="T0" fmla="*/ 136235 w 423732"/>
                    <a:gd name="T1" fmla="*/ 0 h 1335741"/>
                    <a:gd name="T2" fmla="*/ 360353 w 423732"/>
                    <a:gd name="T3" fmla="*/ 233083 h 1335741"/>
                    <a:gd name="T4" fmla="*/ 423106 w 423732"/>
                    <a:gd name="T5" fmla="*/ 430306 h 1335741"/>
                    <a:gd name="T6" fmla="*/ 333459 w 423732"/>
                    <a:gd name="T7" fmla="*/ 546847 h 1335741"/>
                    <a:gd name="T8" fmla="*/ 73482 w 423732"/>
                    <a:gd name="T9" fmla="*/ 788894 h 1335741"/>
                    <a:gd name="T10" fmla="*/ 1764 w 423732"/>
                    <a:gd name="T11" fmla="*/ 1075765 h 1335741"/>
                    <a:gd name="T12" fmla="*/ 127270 w 423732"/>
                    <a:gd name="T13" fmla="*/ 1335741 h 133574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682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20" name="フリーフォーム 119">
                  <a:extLst>
                    <a:ext uri="{FF2B5EF4-FFF2-40B4-BE49-F238E27FC236}">
                      <a16:creationId xmlns:a16="http://schemas.microsoft.com/office/drawing/2014/main" id="{23583383-92D6-72D7-F118-810C2A83E1A5}"/>
                    </a:ext>
                  </a:extLst>
                </p:cNvPr>
                <p:cNvSpPr/>
                <p:nvPr/>
              </p:nvSpPr>
              <p:spPr bwMode="auto">
                <a:xfrm>
                  <a:off x="5354474" y="1121813"/>
                  <a:ext cx="423732" cy="1335741"/>
                </a:xfrm>
                <a:custGeom>
                  <a:avLst/>
                  <a:gdLst>
                    <a:gd name="connsiteX0" fmla="*/ 136235 w 423732"/>
                    <a:gd name="connsiteY0" fmla="*/ 0 h 1335741"/>
                    <a:gd name="connsiteX1" fmla="*/ 360353 w 423732"/>
                    <a:gd name="connsiteY1" fmla="*/ 233083 h 1335741"/>
                    <a:gd name="connsiteX2" fmla="*/ 423106 w 423732"/>
                    <a:gd name="connsiteY2" fmla="*/ 430306 h 1335741"/>
                    <a:gd name="connsiteX3" fmla="*/ 333459 w 423732"/>
                    <a:gd name="connsiteY3" fmla="*/ 546847 h 1335741"/>
                    <a:gd name="connsiteX4" fmla="*/ 73482 w 423732"/>
                    <a:gd name="connsiteY4" fmla="*/ 788894 h 1335741"/>
                    <a:gd name="connsiteX5" fmla="*/ 1764 w 423732"/>
                    <a:gd name="connsiteY5" fmla="*/ 1075765 h 1335741"/>
                    <a:gd name="connsiteX6" fmla="*/ 127270 w 423732"/>
                    <a:gd name="connsiteY6" fmla="*/ 1335741 h 1335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46050" cap="flat" cmpd="sng" algn="ctr">
                  <a:gradFill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71" name="グループ化 230">
                <a:extLst>
                  <a:ext uri="{FF2B5EF4-FFF2-40B4-BE49-F238E27FC236}">
                    <a16:creationId xmlns:a16="http://schemas.microsoft.com/office/drawing/2014/main" id="{AA362ABA-9F23-7F35-9DEE-3192DFADB1E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044250" y="4968851"/>
                <a:ext cx="370692" cy="878702"/>
                <a:chOff x="5477181" y="4771234"/>
                <a:chExt cx="404372" cy="1310884"/>
              </a:xfrm>
            </p:grpSpPr>
            <p:sp>
              <p:nvSpPr>
                <p:cNvPr id="117" name="フリーフォーム 251">
                  <a:extLst>
                    <a:ext uri="{FF2B5EF4-FFF2-40B4-BE49-F238E27FC236}">
                      <a16:creationId xmlns:a16="http://schemas.microsoft.com/office/drawing/2014/main" id="{9439129B-9947-68D0-D587-12DE363D24B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-2542646">
                  <a:off x="5477181" y="4771234"/>
                  <a:ext cx="404371" cy="1308847"/>
                </a:xfrm>
                <a:custGeom>
                  <a:avLst/>
                  <a:gdLst>
                    <a:gd name="T0" fmla="*/ 44824 w 404371"/>
                    <a:gd name="T1" fmla="*/ 0 h 1308847"/>
                    <a:gd name="T2" fmla="*/ 313765 w 404371"/>
                    <a:gd name="T3" fmla="*/ 394447 h 1308847"/>
                    <a:gd name="T4" fmla="*/ 403412 w 404371"/>
                    <a:gd name="T5" fmla="*/ 681318 h 1308847"/>
                    <a:gd name="T6" fmla="*/ 349624 w 404371"/>
                    <a:gd name="T7" fmla="*/ 914400 h 1308847"/>
                    <a:gd name="T8" fmla="*/ 179294 w 404371"/>
                    <a:gd name="T9" fmla="*/ 1066800 h 1308847"/>
                    <a:gd name="T10" fmla="*/ 0 w 404371"/>
                    <a:gd name="T11" fmla="*/ 1308847 h 1308847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0" t="0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18" name="フリーフォーム 117">
                  <a:extLst>
                    <a:ext uri="{FF2B5EF4-FFF2-40B4-BE49-F238E27FC236}">
                      <a16:creationId xmlns:a16="http://schemas.microsoft.com/office/drawing/2014/main" id="{0A70D105-F10B-03B4-7DC2-B6F45A3F07BF}"/>
                    </a:ext>
                  </a:extLst>
                </p:cNvPr>
                <p:cNvSpPr/>
                <p:nvPr/>
              </p:nvSpPr>
              <p:spPr bwMode="auto">
                <a:xfrm rot="19057354">
                  <a:off x="5477182" y="4773271"/>
                  <a:ext cx="404371" cy="1308847"/>
                </a:xfrm>
                <a:custGeom>
                  <a:avLst/>
                  <a:gdLst>
                    <a:gd name="connsiteX0" fmla="*/ 44824 w 404371"/>
                    <a:gd name="connsiteY0" fmla="*/ 0 h 1308847"/>
                    <a:gd name="connsiteX1" fmla="*/ 313765 w 404371"/>
                    <a:gd name="connsiteY1" fmla="*/ 394447 h 1308847"/>
                    <a:gd name="connsiteX2" fmla="*/ 403412 w 404371"/>
                    <a:gd name="connsiteY2" fmla="*/ 681318 h 1308847"/>
                    <a:gd name="connsiteX3" fmla="*/ 349624 w 404371"/>
                    <a:gd name="connsiteY3" fmla="*/ 914400 h 1308847"/>
                    <a:gd name="connsiteX4" fmla="*/ 179294 w 404371"/>
                    <a:gd name="connsiteY4" fmla="*/ 1066800 h 1308847"/>
                    <a:gd name="connsiteX5" fmla="*/ 0 w 404371"/>
                    <a:gd name="connsiteY5" fmla="*/ 1308847 h 130884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50000">
                        <a:srgbClr val="0070C0"/>
                      </a:gs>
                      <a:gs pos="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chemeClr val="accent5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72" name="グループ化 231">
                <a:extLst>
                  <a:ext uri="{FF2B5EF4-FFF2-40B4-BE49-F238E27FC236}">
                    <a16:creationId xmlns:a16="http://schemas.microsoft.com/office/drawing/2014/main" id="{0BF5645E-92A2-BAD3-7364-CF3AAA2F4CF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728872">
                <a:off x="2182012" y="4860447"/>
                <a:ext cx="392389" cy="896185"/>
                <a:chOff x="5350165" y="1120588"/>
                <a:chExt cx="428041" cy="1336966"/>
              </a:xfrm>
            </p:grpSpPr>
            <p:sp>
              <p:nvSpPr>
                <p:cNvPr id="115" name="フリーフォーム 249">
                  <a:extLst>
                    <a:ext uri="{FF2B5EF4-FFF2-40B4-BE49-F238E27FC236}">
                      <a16:creationId xmlns:a16="http://schemas.microsoft.com/office/drawing/2014/main" id="{11555BD8-9868-B8F7-B0EB-BAE19B797BA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0165" y="1120588"/>
                  <a:ext cx="423732" cy="1335741"/>
                </a:xfrm>
                <a:custGeom>
                  <a:avLst/>
                  <a:gdLst>
                    <a:gd name="T0" fmla="*/ 136235 w 423732"/>
                    <a:gd name="T1" fmla="*/ 0 h 1335741"/>
                    <a:gd name="T2" fmla="*/ 360353 w 423732"/>
                    <a:gd name="T3" fmla="*/ 233083 h 1335741"/>
                    <a:gd name="T4" fmla="*/ 423106 w 423732"/>
                    <a:gd name="T5" fmla="*/ 430306 h 1335741"/>
                    <a:gd name="T6" fmla="*/ 333459 w 423732"/>
                    <a:gd name="T7" fmla="*/ 546847 h 1335741"/>
                    <a:gd name="T8" fmla="*/ 73482 w 423732"/>
                    <a:gd name="T9" fmla="*/ 788894 h 1335741"/>
                    <a:gd name="T10" fmla="*/ 1764 w 423732"/>
                    <a:gd name="T11" fmla="*/ 1075765 h 1335741"/>
                    <a:gd name="T12" fmla="*/ 127270 w 423732"/>
                    <a:gd name="T13" fmla="*/ 1335741 h 133574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682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16" name="フリーフォーム 115">
                  <a:extLst>
                    <a:ext uri="{FF2B5EF4-FFF2-40B4-BE49-F238E27FC236}">
                      <a16:creationId xmlns:a16="http://schemas.microsoft.com/office/drawing/2014/main" id="{015A213C-86F5-CAAD-317F-5C2564CE7631}"/>
                    </a:ext>
                  </a:extLst>
                </p:cNvPr>
                <p:cNvSpPr/>
                <p:nvPr/>
              </p:nvSpPr>
              <p:spPr bwMode="auto">
                <a:xfrm>
                  <a:off x="5354474" y="1121813"/>
                  <a:ext cx="423732" cy="1335741"/>
                </a:xfrm>
                <a:custGeom>
                  <a:avLst/>
                  <a:gdLst>
                    <a:gd name="connsiteX0" fmla="*/ 136235 w 423732"/>
                    <a:gd name="connsiteY0" fmla="*/ 0 h 1335741"/>
                    <a:gd name="connsiteX1" fmla="*/ 360353 w 423732"/>
                    <a:gd name="connsiteY1" fmla="*/ 233083 h 1335741"/>
                    <a:gd name="connsiteX2" fmla="*/ 423106 w 423732"/>
                    <a:gd name="connsiteY2" fmla="*/ 430306 h 1335741"/>
                    <a:gd name="connsiteX3" fmla="*/ 333459 w 423732"/>
                    <a:gd name="connsiteY3" fmla="*/ 546847 h 1335741"/>
                    <a:gd name="connsiteX4" fmla="*/ 73482 w 423732"/>
                    <a:gd name="connsiteY4" fmla="*/ 788894 h 1335741"/>
                    <a:gd name="connsiteX5" fmla="*/ 1764 w 423732"/>
                    <a:gd name="connsiteY5" fmla="*/ 1075765 h 1335741"/>
                    <a:gd name="connsiteX6" fmla="*/ 127270 w 423732"/>
                    <a:gd name="connsiteY6" fmla="*/ 1335741 h 1335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46050" cap="flat" cmpd="sng" algn="ctr">
                  <a:gradFill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73" name="グループ化 248">
                <a:extLst>
                  <a:ext uri="{FF2B5EF4-FFF2-40B4-BE49-F238E27FC236}">
                    <a16:creationId xmlns:a16="http://schemas.microsoft.com/office/drawing/2014/main" id="{CD876E97-8CE9-6802-A525-82C8A330A347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400000">
                <a:off x="2018270" y="4844096"/>
                <a:ext cx="286922" cy="1225608"/>
                <a:chOff x="5350165" y="1120588"/>
                <a:chExt cx="428041" cy="1336966"/>
              </a:xfrm>
            </p:grpSpPr>
            <p:sp>
              <p:nvSpPr>
                <p:cNvPr id="113" name="フリーフォーム 247">
                  <a:extLst>
                    <a:ext uri="{FF2B5EF4-FFF2-40B4-BE49-F238E27FC236}">
                      <a16:creationId xmlns:a16="http://schemas.microsoft.com/office/drawing/2014/main" id="{6AF07AE1-5A95-C30C-CC13-D1C0508E716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0165" y="1120588"/>
                  <a:ext cx="423732" cy="1335741"/>
                </a:xfrm>
                <a:custGeom>
                  <a:avLst/>
                  <a:gdLst>
                    <a:gd name="T0" fmla="*/ 136235 w 423732"/>
                    <a:gd name="T1" fmla="*/ 0 h 1335741"/>
                    <a:gd name="T2" fmla="*/ 360353 w 423732"/>
                    <a:gd name="T3" fmla="*/ 233083 h 1335741"/>
                    <a:gd name="T4" fmla="*/ 423106 w 423732"/>
                    <a:gd name="T5" fmla="*/ 430306 h 1335741"/>
                    <a:gd name="T6" fmla="*/ 333459 w 423732"/>
                    <a:gd name="T7" fmla="*/ 546847 h 1335741"/>
                    <a:gd name="T8" fmla="*/ 73482 w 423732"/>
                    <a:gd name="T9" fmla="*/ 788894 h 1335741"/>
                    <a:gd name="T10" fmla="*/ 1764 w 423732"/>
                    <a:gd name="T11" fmla="*/ 1075765 h 1335741"/>
                    <a:gd name="T12" fmla="*/ 127270 w 423732"/>
                    <a:gd name="T13" fmla="*/ 1335741 h 133574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682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14" name="フリーフォーム 113">
                  <a:extLst>
                    <a:ext uri="{FF2B5EF4-FFF2-40B4-BE49-F238E27FC236}">
                      <a16:creationId xmlns:a16="http://schemas.microsoft.com/office/drawing/2014/main" id="{D263FC89-6202-BB35-D559-7975EA15DA9C}"/>
                    </a:ext>
                  </a:extLst>
                </p:cNvPr>
                <p:cNvSpPr/>
                <p:nvPr/>
              </p:nvSpPr>
              <p:spPr bwMode="auto">
                <a:xfrm>
                  <a:off x="5354474" y="1121813"/>
                  <a:ext cx="423732" cy="1335741"/>
                </a:xfrm>
                <a:custGeom>
                  <a:avLst/>
                  <a:gdLst>
                    <a:gd name="connsiteX0" fmla="*/ 136235 w 423732"/>
                    <a:gd name="connsiteY0" fmla="*/ 0 h 1335741"/>
                    <a:gd name="connsiteX1" fmla="*/ 360353 w 423732"/>
                    <a:gd name="connsiteY1" fmla="*/ 233083 h 1335741"/>
                    <a:gd name="connsiteX2" fmla="*/ 423106 w 423732"/>
                    <a:gd name="connsiteY2" fmla="*/ 430306 h 1335741"/>
                    <a:gd name="connsiteX3" fmla="*/ 333459 w 423732"/>
                    <a:gd name="connsiteY3" fmla="*/ 546847 h 1335741"/>
                    <a:gd name="connsiteX4" fmla="*/ 73482 w 423732"/>
                    <a:gd name="connsiteY4" fmla="*/ 788894 h 1335741"/>
                    <a:gd name="connsiteX5" fmla="*/ 1764 w 423732"/>
                    <a:gd name="connsiteY5" fmla="*/ 1075765 h 1335741"/>
                    <a:gd name="connsiteX6" fmla="*/ 127270 w 423732"/>
                    <a:gd name="connsiteY6" fmla="*/ 1335741 h 1335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46050" cap="flat" cmpd="sng" algn="ctr">
                  <a:gradFill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74" name="グループ化 249">
                <a:extLst>
                  <a:ext uri="{FF2B5EF4-FFF2-40B4-BE49-F238E27FC236}">
                    <a16:creationId xmlns:a16="http://schemas.microsoft.com/office/drawing/2014/main" id="{2AFB1F8C-D52A-31BD-9370-57F7FDDFB1F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2795869">
                <a:off x="1662454" y="5044856"/>
                <a:ext cx="949232" cy="525954"/>
                <a:chOff x="6724796" y="3642069"/>
                <a:chExt cx="1165412" cy="573742"/>
              </a:xfrm>
            </p:grpSpPr>
            <p:sp>
              <p:nvSpPr>
                <p:cNvPr id="111" name="フリーフォーム 245">
                  <a:extLst>
                    <a:ext uri="{FF2B5EF4-FFF2-40B4-BE49-F238E27FC236}">
                      <a16:creationId xmlns:a16="http://schemas.microsoft.com/office/drawing/2014/main" id="{7F47D31F-1197-852A-8C81-1244C195924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24796" y="3642070"/>
                  <a:ext cx="1165412" cy="573741"/>
                </a:xfrm>
                <a:custGeom>
                  <a:avLst/>
                  <a:gdLst>
                    <a:gd name="T0" fmla="*/ 0 w 1165412"/>
                    <a:gd name="T1" fmla="*/ 573741 h 573741"/>
                    <a:gd name="T2" fmla="*/ 277906 w 1165412"/>
                    <a:gd name="T3" fmla="*/ 277906 h 573741"/>
                    <a:gd name="T4" fmla="*/ 528918 w 1165412"/>
                    <a:gd name="T5" fmla="*/ 233082 h 573741"/>
                    <a:gd name="T6" fmla="*/ 968189 w 1165412"/>
                    <a:gd name="T7" fmla="*/ 152400 h 573741"/>
                    <a:gd name="T8" fmla="*/ 1165412 w 1165412"/>
                    <a:gd name="T9" fmla="*/ 0 h 573741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12" name="フリーフォーム 111">
                  <a:extLst>
                    <a:ext uri="{FF2B5EF4-FFF2-40B4-BE49-F238E27FC236}">
                      <a16:creationId xmlns:a16="http://schemas.microsoft.com/office/drawing/2014/main" id="{F8DF12FF-5EB7-5328-43CF-298CEECFA5E3}"/>
                    </a:ext>
                  </a:extLst>
                </p:cNvPr>
                <p:cNvSpPr/>
                <p:nvPr/>
              </p:nvSpPr>
              <p:spPr bwMode="auto">
                <a:xfrm>
                  <a:off x="6724796" y="3642069"/>
                  <a:ext cx="1165412" cy="573741"/>
                </a:xfrm>
                <a:custGeom>
                  <a:avLst/>
                  <a:gdLst>
                    <a:gd name="connsiteX0" fmla="*/ 0 w 1165412"/>
                    <a:gd name="connsiteY0" fmla="*/ 573741 h 573741"/>
                    <a:gd name="connsiteX1" fmla="*/ 277906 w 1165412"/>
                    <a:gd name="connsiteY1" fmla="*/ 277906 h 573741"/>
                    <a:gd name="connsiteX2" fmla="*/ 528918 w 1165412"/>
                    <a:gd name="connsiteY2" fmla="*/ 233082 h 573741"/>
                    <a:gd name="connsiteX3" fmla="*/ 968189 w 1165412"/>
                    <a:gd name="connsiteY3" fmla="*/ 152400 h 573741"/>
                    <a:gd name="connsiteX4" fmla="*/ 1165412 w 1165412"/>
                    <a:gd name="connsiteY4" fmla="*/ 0 h 573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3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75" name="グループ化 250">
                <a:extLst>
                  <a:ext uri="{FF2B5EF4-FFF2-40B4-BE49-F238E27FC236}">
                    <a16:creationId xmlns:a16="http://schemas.microsoft.com/office/drawing/2014/main" id="{69C08B83-9096-448A-42DE-159B06BFD83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6791888">
                <a:off x="2049740" y="5020391"/>
                <a:ext cx="949232" cy="525954"/>
                <a:chOff x="6724796" y="3642069"/>
                <a:chExt cx="1165412" cy="573742"/>
              </a:xfrm>
            </p:grpSpPr>
            <p:sp>
              <p:nvSpPr>
                <p:cNvPr id="109" name="フリーフォーム 243">
                  <a:extLst>
                    <a:ext uri="{FF2B5EF4-FFF2-40B4-BE49-F238E27FC236}">
                      <a16:creationId xmlns:a16="http://schemas.microsoft.com/office/drawing/2014/main" id="{BB4FBF2E-AC68-65DF-9F31-2056DD768DA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24796" y="3642070"/>
                  <a:ext cx="1165412" cy="573741"/>
                </a:xfrm>
                <a:custGeom>
                  <a:avLst/>
                  <a:gdLst>
                    <a:gd name="T0" fmla="*/ 0 w 1165412"/>
                    <a:gd name="T1" fmla="*/ 573741 h 573741"/>
                    <a:gd name="T2" fmla="*/ 277906 w 1165412"/>
                    <a:gd name="T3" fmla="*/ 277906 h 573741"/>
                    <a:gd name="T4" fmla="*/ 528918 w 1165412"/>
                    <a:gd name="T5" fmla="*/ 233082 h 573741"/>
                    <a:gd name="T6" fmla="*/ 968189 w 1165412"/>
                    <a:gd name="T7" fmla="*/ 152400 h 573741"/>
                    <a:gd name="T8" fmla="*/ 1165412 w 1165412"/>
                    <a:gd name="T9" fmla="*/ 0 h 573741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110" name="フリーフォーム 109">
                  <a:extLst>
                    <a:ext uri="{FF2B5EF4-FFF2-40B4-BE49-F238E27FC236}">
                      <a16:creationId xmlns:a16="http://schemas.microsoft.com/office/drawing/2014/main" id="{29F8382E-E687-70C9-35A1-387FD469658D}"/>
                    </a:ext>
                  </a:extLst>
                </p:cNvPr>
                <p:cNvSpPr/>
                <p:nvPr/>
              </p:nvSpPr>
              <p:spPr bwMode="auto">
                <a:xfrm>
                  <a:off x="6724796" y="3642069"/>
                  <a:ext cx="1165412" cy="573741"/>
                </a:xfrm>
                <a:custGeom>
                  <a:avLst/>
                  <a:gdLst>
                    <a:gd name="connsiteX0" fmla="*/ 0 w 1165412"/>
                    <a:gd name="connsiteY0" fmla="*/ 573741 h 573741"/>
                    <a:gd name="connsiteX1" fmla="*/ 277906 w 1165412"/>
                    <a:gd name="connsiteY1" fmla="*/ 277906 h 573741"/>
                    <a:gd name="connsiteX2" fmla="*/ 528918 w 1165412"/>
                    <a:gd name="connsiteY2" fmla="*/ 233082 h 573741"/>
                    <a:gd name="connsiteX3" fmla="*/ 968189 w 1165412"/>
                    <a:gd name="connsiteY3" fmla="*/ 152400 h 573741"/>
                    <a:gd name="connsiteX4" fmla="*/ 1165412 w 1165412"/>
                    <a:gd name="connsiteY4" fmla="*/ 0 h 573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3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sp>
            <p:nvSpPr>
              <p:cNvPr id="76" name="円/楕円 75">
                <a:extLst>
                  <a:ext uri="{FF2B5EF4-FFF2-40B4-BE49-F238E27FC236}">
                    <a16:creationId xmlns:a16="http://schemas.microsoft.com/office/drawing/2014/main" id="{ED3BF4EE-1B3C-7439-73D7-C3EEEC5ACD51}"/>
                  </a:ext>
                </a:extLst>
              </p:cNvPr>
              <p:cNvSpPr/>
              <p:nvPr/>
            </p:nvSpPr>
            <p:spPr bwMode="auto">
              <a:xfrm>
                <a:off x="2478555" y="4742284"/>
                <a:ext cx="141298" cy="78360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77" name="円/楕円 76">
                <a:extLst>
                  <a:ext uri="{FF2B5EF4-FFF2-40B4-BE49-F238E27FC236}">
                    <a16:creationId xmlns:a16="http://schemas.microsoft.com/office/drawing/2014/main" id="{763D76BF-080B-D6A4-CD9B-E7565FEDC0C6}"/>
                  </a:ext>
                </a:extLst>
              </p:cNvPr>
              <p:cNvSpPr/>
              <p:nvPr/>
            </p:nvSpPr>
            <p:spPr bwMode="auto">
              <a:xfrm>
                <a:off x="1533672" y="5619547"/>
                <a:ext cx="141298" cy="78360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78" name="円/楕円 77">
                <a:extLst>
                  <a:ext uri="{FF2B5EF4-FFF2-40B4-BE49-F238E27FC236}">
                    <a16:creationId xmlns:a16="http://schemas.microsoft.com/office/drawing/2014/main" id="{BE717CD1-9EBF-2390-2676-4C4EB6C1517C}"/>
                  </a:ext>
                </a:extLst>
              </p:cNvPr>
              <p:cNvSpPr/>
              <p:nvPr/>
            </p:nvSpPr>
            <p:spPr bwMode="auto">
              <a:xfrm>
                <a:off x="1550077" y="4753752"/>
                <a:ext cx="141298" cy="78360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grpSp>
            <p:nvGrpSpPr>
              <p:cNvPr id="79" name="グループ化 259">
                <a:extLst>
                  <a:ext uri="{FF2B5EF4-FFF2-40B4-BE49-F238E27FC236}">
                    <a16:creationId xmlns:a16="http://schemas.microsoft.com/office/drawing/2014/main" id="{5A15F713-2DA3-8328-59C6-3E826900BEF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958163" y="4775644"/>
                <a:ext cx="516908" cy="930918"/>
                <a:chOff x="2930453" y="4198301"/>
                <a:chExt cx="567025" cy="1335929"/>
              </a:xfrm>
            </p:grpSpPr>
            <p:grpSp>
              <p:nvGrpSpPr>
                <p:cNvPr id="104" name="グループ化 347">
                  <a:extLst>
                    <a:ext uri="{FF2B5EF4-FFF2-40B4-BE49-F238E27FC236}">
                      <a16:creationId xmlns:a16="http://schemas.microsoft.com/office/drawing/2014/main" id="{0A78D0C8-94DC-8557-9380-4E7157C53D03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126843">
                  <a:off x="2930453" y="4268074"/>
                  <a:ext cx="406631" cy="1259035"/>
                  <a:chOff x="8189975" y="1357391"/>
                  <a:chExt cx="404371" cy="1308847"/>
                </a:xfrm>
              </p:grpSpPr>
              <p:sp>
                <p:nvSpPr>
                  <p:cNvPr id="107" name="フリーフォーム 241">
                    <a:extLst>
                      <a:ext uri="{FF2B5EF4-FFF2-40B4-BE49-F238E27FC236}">
                        <a16:creationId xmlns:a16="http://schemas.microsoft.com/office/drawing/2014/main" id="{9DF164D4-048D-4D01-C3E6-8E8D68DEE35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08" name="フリーフォーム 107">
                    <a:extLst>
                      <a:ext uri="{FF2B5EF4-FFF2-40B4-BE49-F238E27FC236}">
                        <a16:creationId xmlns:a16="http://schemas.microsoft.com/office/drawing/2014/main" id="{ED2105EF-1E65-9DF3-E8A8-1956EDBD042C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0">
                          <a:srgbClr val="0070C0"/>
                        </a:gs>
                        <a:gs pos="5000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rgbClr val="0070C0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105" name="円/楕円 104">
                  <a:extLst>
                    <a:ext uri="{FF2B5EF4-FFF2-40B4-BE49-F238E27FC236}">
                      <a16:creationId xmlns:a16="http://schemas.microsoft.com/office/drawing/2014/main" id="{3A7E04FF-AAD1-F4F0-511C-8E44CA16F7B7}"/>
                    </a:ext>
                  </a:extLst>
                </p:cNvPr>
                <p:cNvSpPr/>
                <p:nvPr/>
              </p:nvSpPr>
              <p:spPr bwMode="auto">
                <a:xfrm>
                  <a:off x="3342480" y="5421778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  <p:sp>
              <p:nvSpPr>
                <p:cNvPr id="106" name="円/楕円 105">
                  <a:extLst>
                    <a:ext uri="{FF2B5EF4-FFF2-40B4-BE49-F238E27FC236}">
                      <a16:creationId xmlns:a16="http://schemas.microsoft.com/office/drawing/2014/main" id="{8341E919-B883-28D1-D165-B2B02FA1E135}"/>
                    </a:ext>
                  </a:extLst>
                </p:cNvPr>
                <p:cNvSpPr/>
                <p:nvPr/>
              </p:nvSpPr>
              <p:spPr bwMode="auto">
                <a:xfrm>
                  <a:off x="3116359" y="4198301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sp>
            <p:nvSpPr>
              <p:cNvPr id="80" name="円/楕円 79">
                <a:extLst>
                  <a:ext uri="{FF2B5EF4-FFF2-40B4-BE49-F238E27FC236}">
                    <a16:creationId xmlns:a16="http://schemas.microsoft.com/office/drawing/2014/main" id="{EAF13108-FBC8-9BDE-EBE1-73BD658710EA}"/>
                  </a:ext>
                </a:extLst>
              </p:cNvPr>
              <p:cNvSpPr/>
              <p:nvPr/>
            </p:nvSpPr>
            <p:spPr bwMode="auto">
              <a:xfrm>
                <a:off x="2435437" y="5740169"/>
                <a:ext cx="141298" cy="78360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81" name="フリーフォーム 215">
                <a:extLst>
                  <a:ext uri="{FF2B5EF4-FFF2-40B4-BE49-F238E27FC236}">
                    <a16:creationId xmlns:a16="http://schemas.microsoft.com/office/drawing/2014/main" id="{38D70CC6-307F-4F50-7183-614A047CBB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1652" y="5148555"/>
                <a:ext cx="106835" cy="42065"/>
              </a:xfrm>
              <a:custGeom>
                <a:avLst/>
                <a:gdLst>
                  <a:gd name="T0" fmla="*/ 63402 w 116542"/>
                  <a:gd name="T1" fmla="*/ 3816 h 62753"/>
                  <a:gd name="T2" fmla="*/ 0 w 116542"/>
                  <a:gd name="T3" fmla="*/ 0 h 6275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16542" h="62753">
                    <a:moveTo>
                      <a:pt x="116542" y="62753"/>
                    </a:moveTo>
                    <a:cubicBezTo>
                      <a:pt x="40342" y="29882"/>
                      <a:pt x="59765" y="43329"/>
                      <a:pt x="0" y="0"/>
                    </a:cubicBezTo>
                  </a:path>
                </a:pathLst>
              </a:custGeom>
              <a:noFill/>
              <a:ln w="15875" cap="flat" cmpd="sng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anchor="ctr"/>
              <a:lstStyle/>
              <a:p>
                <a:endParaRPr lang="ja-JP" altLang="en-US"/>
              </a:p>
            </p:txBody>
          </p:sp>
          <p:sp>
            <p:nvSpPr>
              <p:cNvPr id="82" name="フリーフォーム 216">
                <a:extLst>
                  <a:ext uri="{FF2B5EF4-FFF2-40B4-BE49-F238E27FC236}">
                    <a16:creationId xmlns:a16="http://schemas.microsoft.com/office/drawing/2014/main" id="{562AE6FD-53C2-0FAD-7B09-D2EEE15E1CCF}"/>
                  </a:ext>
                </a:extLst>
              </p:cNvPr>
              <p:cNvSpPr>
                <a:spLocks/>
              </p:cNvSpPr>
              <p:nvPr/>
            </p:nvSpPr>
            <p:spPr bwMode="auto">
              <a:xfrm rot="-1178287">
                <a:off x="2318825" y="4819112"/>
                <a:ext cx="132416" cy="23893"/>
              </a:xfrm>
              <a:custGeom>
                <a:avLst/>
                <a:gdLst>
                  <a:gd name="T0" fmla="*/ 199276564 w 39116"/>
                  <a:gd name="T1" fmla="*/ 757254 h 13431"/>
                  <a:gd name="T2" fmla="*/ 0 w 39116"/>
                  <a:gd name="T3" fmla="*/ 0 h 13431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9116" h="13431">
                    <a:moveTo>
                      <a:pt x="39116" y="13431"/>
                    </a:moveTo>
                    <a:lnTo>
                      <a:pt x="0" y="0"/>
                    </a:lnTo>
                  </a:path>
                </a:pathLst>
              </a:custGeom>
              <a:noFill/>
              <a:ln w="15875" cap="flat" cmpd="sng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anchor="ctr"/>
              <a:lstStyle/>
              <a:p>
                <a:endParaRPr lang="ja-JP" altLang="en-US"/>
              </a:p>
            </p:txBody>
          </p:sp>
          <p:grpSp>
            <p:nvGrpSpPr>
              <p:cNvPr id="83" name="グループ化 263">
                <a:extLst>
                  <a:ext uri="{FF2B5EF4-FFF2-40B4-BE49-F238E27FC236}">
                    <a16:creationId xmlns:a16="http://schemas.microsoft.com/office/drawing/2014/main" id="{DFE5F0C2-44F2-CDC1-323A-4E1AFA2AFA21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568690" y="4762770"/>
                <a:ext cx="521395" cy="942614"/>
                <a:chOff x="1017959" y="4218171"/>
                <a:chExt cx="571947" cy="1352713"/>
              </a:xfrm>
            </p:grpSpPr>
            <p:grpSp>
              <p:nvGrpSpPr>
                <p:cNvPr id="99" name="グループ化 342">
                  <a:extLst>
                    <a:ext uri="{FF2B5EF4-FFF2-40B4-BE49-F238E27FC236}">
                      <a16:creationId xmlns:a16="http://schemas.microsoft.com/office/drawing/2014/main" id="{6AC61F0F-87D6-E3E0-77FA-031F6747FE54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-10337146">
                  <a:off x="1017959" y="4248206"/>
                  <a:ext cx="406631" cy="1259035"/>
                  <a:chOff x="8189975" y="1357391"/>
                  <a:chExt cx="404371" cy="1308847"/>
                </a:xfrm>
              </p:grpSpPr>
              <p:sp>
                <p:nvSpPr>
                  <p:cNvPr id="102" name="フリーフォーム 236">
                    <a:extLst>
                      <a:ext uri="{FF2B5EF4-FFF2-40B4-BE49-F238E27FC236}">
                        <a16:creationId xmlns:a16="http://schemas.microsoft.com/office/drawing/2014/main" id="{BC251606-DA60-A477-786A-47409DAF670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03" name="フリーフォーム 102">
                    <a:extLst>
                      <a:ext uri="{FF2B5EF4-FFF2-40B4-BE49-F238E27FC236}">
                        <a16:creationId xmlns:a16="http://schemas.microsoft.com/office/drawing/2014/main" id="{C0E7D970-1584-C21E-FABC-FD0298F9D5A1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0">
                          <a:srgbClr val="0070C0"/>
                        </a:gs>
                        <a:gs pos="5000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rgbClr val="0070C0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100" name="円/楕円 99">
                  <a:extLst>
                    <a:ext uri="{FF2B5EF4-FFF2-40B4-BE49-F238E27FC236}">
                      <a16:creationId xmlns:a16="http://schemas.microsoft.com/office/drawing/2014/main" id="{FEF742D7-A733-B19D-B485-9CD1625D86A9}"/>
                    </a:ext>
                  </a:extLst>
                </p:cNvPr>
                <p:cNvSpPr/>
                <p:nvPr/>
              </p:nvSpPr>
              <p:spPr bwMode="auto">
                <a:xfrm>
                  <a:off x="1413308" y="4218171"/>
                  <a:ext cx="176598" cy="12842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  <p:sp>
              <p:nvSpPr>
                <p:cNvPr id="101" name="円/楕円 100">
                  <a:extLst>
                    <a:ext uri="{FF2B5EF4-FFF2-40B4-BE49-F238E27FC236}">
                      <a16:creationId xmlns:a16="http://schemas.microsoft.com/office/drawing/2014/main" id="{89F8F940-BF7F-BA21-7023-F7B4EDF324D1}"/>
                    </a:ext>
                  </a:extLst>
                </p:cNvPr>
                <p:cNvSpPr/>
                <p:nvPr/>
              </p:nvSpPr>
              <p:spPr bwMode="auto">
                <a:xfrm>
                  <a:off x="1216003" y="5458432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84" name="グループ化 264">
                <a:extLst>
                  <a:ext uri="{FF2B5EF4-FFF2-40B4-BE49-F238E27FC236}">
                    <a16:creationId xmlns:a16="http://schemas.microsoft.com/office/drawing/2014/main" id="{C4F7C2AC-BF93-1CDA-B828-2F4DE835381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457251" y="5042159"/>
                <a:ext cx="1348306" cy="384587"/>
                <a:chOff x="770000" y="4868176"/>
                <a:chExt cx="1479031" cy="551907"/>
              </a:xfrm>
            </p:grpSpPr>
            <p:grpSp>
              <p:nvGrpSpPr>
                <p:cNvPr id="95" name="グループ化 338">
                  <a:extLst>
                    <a:ext uri="{FF2B5EF4-FFF2-40B4-BE49-F238E27FC236}">
                      <a16:creationId xmlns:a16="http://schemas.microsoft.com/office/drawing/2014/main" id="{12D941A3-57F9-3317-42D6-7D9F5445ACC4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-8842590">
                  <a:off x="825014" y="4868176"/>
                  <a:ext cx="1424017" cy="551907"/>
                  <a:chOff x="6724796" y="3642069"/>
                  <a:chExt cx="1165412" cy="573742"/>
                </a:xfrm>
              </p:grpSpPr>
              <p:sp>
                <p:nvSpPr>
                  <p:cNvPr id="97" name="フリーフォーム 231">
                    <a:extLst>
                      <a:ext uri="{FF2B5EF4-FFF2-40B4-BE49-F238E27FC236}">
                        <a16:creationId xmlns:a16="http://schemas.microsoft.com/office/drawing/2014/main" id="{03C395A6-CEAE-1C71-D2E1-E64B8976959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724796" y="3642070"/>
                    <a:ext cx="1165412" cy="573741"/>
                  </a:xfrm>
                  <a:custGeom>
                    <a:avLst/>
                    <a:gdLst>
                      <a:gd name="T0" fmla="*/ 0 w 1165412"/>
                      <a:gd name="T1" fmla="*/ 573741 h 573741"/>
                      <a:gd name="T2" fmla="*/ 277906 w 1165412"/>
                      <a:gd name="T3" fmla="*/ 277906 h 573741"/>
                      <a:gd name="T4" fmla="*/ 528918 w 1165412"/>
                      <a:gd name="T5" fmla="*/ 233082 h 573741"/>
                      <a:gd name="T6" fmla="*/ 968189 w 1165412"/>
                      <a:gd name="T7" fmla="*/ 152400 h 573741"/>
                      <a:gd name="T8" fmla="*/ 1165412 w 1165412"/>
                      <a:gd name="T9" fmla="*/ 0 h 573741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1165412" h="573741">
                        <a:moveTo>
                          <a:pt x="0" y="573741"/>
                        </a:moveTo>
                        <a:cubicBezTo>
                          <a:pt x="94876" y="454211"/>
                          <a:pt x="189753" y="334682"/>
                          <a:pt x="277906" y="277906"/>
                        </a:cubicBezTo>
                        <a:cubicBezTo>
                          <a:pt x="366059" y="221130"/>
                          <a:pt x="528918" y="233082"/>
                          <a:pt x="528918" y="233082"/>
                        </a:cubicBezTo>
                        <a:cubicBezTo>
                          <a:pt x="643965" y="212164"/>
                          <a:pt x="862107" y="191247"/>
                          <a:pt x="968189" y="152400"/>
                        </a:cubicBezTo>
                        <a:cubicBezTo>
                          <a:pt x="1074271" y="113553"/>
                          <a:pt x="1119841" y="56776"/>
                          <a:pt x="1165412" y="0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98" name="フリーフォーム 97">
                    <a:extLst>
                      <a:ext uri="{FF2B5EF4-FFF2-40B4-BE49-F238E27FC236}">
                        <a16:creationId xmlns:a16="http://schemas.microsoft.com/office/drawing/2014/main" id="{9A0BCAFC-4617-D7DF-0615-14E5AB9BEDA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6724796" y="3642069"/>
                    <a:ext cx="1165412" cy="573741"/>
                  </a:xfrm>
                  <a:custGeom>
                    <a:avLst/>
                    <a:gdLst>
                      <a:gd name="connsiteX0" fmla="*/ 0 w 1165412"/>
                      <a:gd name="connsiteY0" fmla="*/ 573741 h 573741"/>
                      <a:gd name="connsiteX1" fmla="*/ 277906 w 1165412"/>
                      <a:gd name="connsiteY1" fmla="*/ 277906 h 573741"/>
                      <a:gd name="connsiteX2" fmla="*/ 528918 w 1165412"/>
                      <a:gd name="connsiteY2" fmla="*/ 233082 h 573741"/>
                      <a:gd name="connsiteX3" fmla="*/ 968189 w 1165412"/>
                      <a:gd name="connsiteY3" fmla="*/ 152400 h 573741"/>
                      <a:gd name="connsiteX4" fmla="*/ 1165412 w 1165412"/>
                      <a:gd name="connsiteY4" fmla="*/ 0 h 57374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165412" h="573741">
                        <a:moveTo>
                          <a:pt x="0" y="573741"/>
                        </a:moveTo>
                        <a:cubicBezTo>
                          <a:pt x="94876" y="454211"/>
                          <a:pt x="189753" y="334682"/>
                          <a:pt x="277906" y="277906"/>
                        </a:cubicBezTo>
                        <a:cubicBezTo>
                          <a:pt x="366059" y="221130"/>
                          <a:pt x="528918" y="233082"/>
                          <a:pt x="528918" y="233082"/>
                        </a:cubicBezTo>
                        <a:cubicBezTo>
                          <a:pt x="643965" y="212164"/>
                          <a:pt x="862107" y="191247"/>
                          <a:pt x="968189" y="152400"/>
                        </a:cubicBezTo>
                        <a:cubicBezTo>
                          <a:pt x="1074271" y="113553"/>
                          <a:pt x="1119841" y="56776"/>
                          <a:pt x="1165412" y="0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50000">
                          <a:srgbClr val="0070C0"/>
                        </a:gs>
                        <a:gs pos="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chemeClr val="accent5"/>
                        </a:gs>
                      </a:gsLst>
                      <a:lin ang="8400000" scaled="0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96" name="フリーフォーム 230">
                  <a:extLst>
                    <a:ext uri="{FF2B5EF4-FFF2-40B4-BE49-F238E27FC236}">
                      <a16:creationId xmlns:a16="http://schemas.microsoft.com/office/drawing/2014/main" id="{DC5A1AEA-8A56-7907-CECB-B65CA646D1A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70000" y="4929787"/>
                  <a:ext cx="45974" cy="158988"/>
                </a:xfrm>
                <a:custGeom>
                  <a:avLst/>
                  <a:gdLst>
                    <a:gd name="T0" fmla="*/ 36239 w 47834"/>
                    <a:gd name="T1" fmla="*/ 2147483647 h 32132"/>
                    <a:gd name="T2" fmla="*/ 0 w 47834"/>
                    <a:gd name="T3" fmla="*/ 0 h 32132"/>
                    <a:gd name="T4" fmla="*/ 0 60000 65536"/>
                    <a:gd name="T5" fmla="*/ 0 60000 65536"/>
                  </a:gdLst>
                  <a:ahLst/>
                  <a:cxnLst>
                    <a:cxn ang="T4">
                      <a:pos x="T0" y="T1"/>
                    </a:cxn>
                    <a:cxn ang="T5">
                      <a:pos x="T2" y="T3"/>
                    </a:cxn>
                  </a:cxnLst>
                  <a:rect l="0" t="0" r="r" b="b"/>
                  <a:pathLst>
                    <a:path w="47834" h="32132">
                      <a:moveTo>
                        <a:pt x="47834" y="31018"/>
                      </a:moveTo>
                      <a:cubicBezTo>
                        <a:pt x="40342" y="29882"/>
                        <a:pt x="59765" y="43329"/>
                        <a:pt x="0" y="0"/>
                      </a:cubicBezTo>
                    </a:path>
                  </a:pathLst>
                </a:custGeom>
                <a:noFill/>
                <a:ln w="158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85" name="グループ化 265">
                <a:extLst>
                  <a:ext uri="{FF2B5EF4-FFF2-40B4-BE49-F238E27FC236}">
                    <a16:creationId xmlns:a16="http://schemas.microsoft.com/office/drawing/2014/main" id="{E0726EE7-2A24-6711-5FE9-2F0B6E78261E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518190" y="5305122"/>
                <a:ext cx="1210116" cy="304803"/>
                <a:chOff x="2554579" y="6031689"/>
                <a:chExt cx="1327443" cy="437412"/>
              </a:xfrm>
            </p:grpSpPr>
            <p:grpSp>
              <p:nvGrpSpPr>
                <p:cNvPr id="91" name="グループ化 334">
                  <a:extLst>
                    <a:ext uri="{FF2B5EF4-FFF2-40B4-BE49-F238E27FC236}">
                      <a16:creationId xmlns:a16="http://schemas.microsoft.com/office/drawing/2014/main" id="{10F75649-1683-C36B-019A-C5A103D71939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6134345">
                  <a:off x="3028427" y="5567075"/>
                  <a:ext cx="388982" cy="1318209"/>
                  <a:chOff x="5477181" y="4771234"/>
                  <a:chExt cx="404372" cy="1310884"/>
                </a:xfrm>
              </p:grpSpPr>
              <p:sp>
                <p:nvSpPr>
                  <p:cNvPr id="93" name="フリーフォーム 227">
                    <a:extLst>
                      <a:ext uri="{FF2B5EF4-FFF2-40B4-BE49-F238E27FC236}">
                        <a16:creationId xmlns:a16="http://schemas.microsoft.com/office/drawing/2014/main" id="{2711C558-9F6F-729B-ACB6-510C047BE2D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 rot="-2542646">
                    <a:off x="5477181" y="4771234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94" name="フリーフォーム 93">
                    <a:extLst>
                      <a:ext uri="{FF2B5EF4-FFF2-40B4-BE49-F238E27FC236}">
                        <a16:creationId xmlns:a16="http://schemas.microsoft.com/office/drawing/2014/main" id="{499B0E62-1A81-ECEE-3CF2-952FBEDC66BE}"/>
                      </a:ext>
                    </a:extLst>
                  </p:cNvPr>
                  <p:cNvSpPr/>
                  <p:nvPr/>
                </p:nvSpPr>
                <p:spPr bwMode="auto">
                  <a:xfrm rot="19057354">
                    <a:off x="5477182" y="477327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50000">
                          <a:srgbClr val="0070C0"/>
                        </a:gs>
                        <a:gs pos="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chemeClr val="accent5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92" name="フリーフォーム 226">
                  <a:extLst>
                    <a:ext uri="{FF2B5EF4-FFF2-40B4-BE49-F238E27FC236}">
                      <a16:creationId xmlns:a16="http://schemas.microsoft.com/office/drawing/2014/main" id="{D144A260-C8E9-C59C-AA05-3A7E8BE7A85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flipH="1">
                  <a:off x="2554579" y="6309224"/>
                  <a:ext cx="18870" cy="159877"/>
                </a:xfrm>
                <a:custGeom>
                  <a:avLst/>
                  <a:gdLst>
                    <a:gd name="T0" fmla="*/ 71 w 47834"/>
                    <a:gd name="T1" fmla="*/ 2147483647 h 32132"/>
                    <a:gd name="T2" fmla="*/ 0 w 47834"/>
                    <a:gd name="T3" fmla="*/ 0 h 32132"/>
                    <a:gd name="T4" fmla="*/ 0 60000 65536"/>
                    <a:gd name="T5" fmla="*/ 0 60000 65536"/>
                  </a:gdLst>
                  <a:ahLst/>
                  <a:cxnLst>
                    <a:cxn ang="T4">
                      <a:pos x="T0" y="T1"/>
                    </a:cxn>
                    <a:cxn ang="T5">
                      <a:pos x="T2" y="T3"/>
                    </a:cxn>
                  </a:cxnLst>
                  <a:rect l="0" t="0" r="r" b="b"/>
                  <a:pathLst>
                    <a:path w="47834" h="32132">
                      <a:moveTo>
                        <a:pt x="47834" y="31018"/>
                      </a:moveTo>
                      <a:cubicBezTo>
                        <a:pt x="40342" y="29882"/>
                        <a:pt x="59765" y="43329"/>
                        <a:pt x="0" y="0"/>
                      </a:cubicBezTo>
                    </a:path>
                  </a:pathLst>
                </a:custGeom>
                <a:noFill/>
                <a:ln w="158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86" name="グループ化 266">
                <a:extLst>
                  <a:ext uri="{FF2B5EF4-FFF2-40B4-BE49-F238E27FC236}">
                    <a16:creationId xmlns:a16="http://schemas.microsoft.com/office/drawing/2014/main" id="{94F6BF66-D8C2-DD3F-B0E2-6F697235208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060104" y="4864873"/>
                <a:ext cx="700540" cy="877336"/>
                <a:chOff x="1443961" y="4402964"/>
                <a:chExt cx="768461" cy="1259035"/>
              </a:xfrm>
            </p:grpSpPr>
            <p:grpSp>
              <p:nvGrpSpPr>
                <p:cNvPr id="87" name="グループ化 330">
                  <a:extLst>
                    <a:ext uri="{FF2B5EF4-FFF2-40B4-BE49-F238E27FC236}">
                      <a16:creationId xmlns:a16="http://schemas.microsoft.com/office/drawing/2014/main" id="{EFBC4DC0-75F6-0924-E3D2-AF372BF55F78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-2192002">
                  <a:off x="1805791" y="4402964"/>
                  <a:ext cx="406631" cy="1259035"/>
                  <a:chOff x="8189975" y="1357391"/>
                  <a:chExt cx="404371" cy="1308847"/>
                </a:xfrm>
              </p:grpSpPr>
              <p:sp>
                <p:nvSpPr>
                  <p:cNvPr id="89" name="フリーフォーム 223">
                    <a:extLst>
                      <a:ext uri="{FF2B5EF4-FFF2-40B4-BE49-F238E27FC236}">
                        <a16:creationId xmlns:a16="http://schemas.microsoft.com/office/drawing/2014/main" id="{94A4F523-5BCD-B6DD-6EBF-9949F741338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90" name="フリーフォーム 89">
                    <a:extLst>
                      <a:ext uri="{FF2B5EF4-FFF2-40B4-BE49-F238E27FC236}">
                        <a16:creationId xmlns:a16="http://schemas.microsoft.com/office/drawing/2014/main" id="{BA36D295-7C5D-3B81-81E2-6F56D6C0AEFC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0">
                          <a:srgbClr val="0070C0"/>
                        </a:gs>
                        <a:gs pos="5000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rgbClr val="0070C0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88" name="円/楕円 87">
                  <a:extLst>
                    <a:ext uri="{FF2B5EF4-FFF2-40B4-BE49-F238E27FC236}">
                      <a16:creationId xmlns:a16="http://schemas.microsoft.com/office/drawing/2014/main" id="{76033B7F-B029-C4A5-AAAB-9A1680988AED}"/>
                    </a:ext>
                  </a:extLst>
                </p:cNvPr>
                <p:cNvSpPr/>
                <p:nvPr/>
              </p:nvSpPr>
              <p:spPr bwMode="auto">
                <a:xfrm>
                  <a:off x="1443961" y="4569075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50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</p:grpSp>
        <p:grpSp>
          <p:nvGrpSpPr>
            <p:cNvPr id="11" name="グループ化 21">
              <a:extLst>
                <a:ext uri="{FF2B5EF4-FFF2-40B4-BE49-F238E27FC236}">
                  <a16:creationId xmlns:a16="http://schemas.microsoft.com/office/drawing/2014/main" id="{89A9E6BC-E49A-F370-1E42-C0CE88E1130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506538" y="4673526"/>
              <a:ext cx="1236081" cy="1244719"/>
              <a:chOff x="6506538" y="4749769"/>
              <a:chExt cx="1453499" cy="1168476"/>
            </a:xfrm>
          </p:grpSpPr>
          <p:grpSp>
            <p:nvGrpSpPr>
              <p:cNvPr id="16" name="グループ化 267">
                <a:extLst>
                  <a:ext uri="{FF2B5EF4-FFF2-40B4-BE49-F238E27FC236}">
                    <a16:creationId xmlns:a16="http://schemas.microsoft.com/office/drawing/2014/main" id="{CA1CB06D-E19C-C896-BA13-4494C63B261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845225">
                <a:off x="6569252" y="4902512"/>
                <a:ext cx="1309023" cy="406580"/>
                <a:chOff x="6724796" y="3642069"/>
                <a:chExt cx="1165412" cy="573742"/>
              </a:xfrm>
            </p:grpSpPr>
            <p:sp>
              <p:nvSpPr>
                <p:cNvPr id="66" name="フリーフォーム 200">
                  <a:extLst>
                    <a:ext uri="{FF2B5EF4-FFF2-40B4-BE49-F238E27FC236}">
                      <a16:creationId xmlns:a16="http://schemas.microsoft.com/office/drawing/2014/main" id="{A078739E-85F4-2413-6436-0DBD9DBD3E1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24796" y="3642070"/>
                  <a:ext cx="1165412" cy="573741"/>
                </a:xfrm>
                <a:custGeom>
                  <a:avLst/>
                  <a:gdLst>
                    <a:gd name="T0" fmla="*/ 0 w 1165412"/>
                    <a:gd name="T1" fmla="*/ 573741 h 573741"/>
                    <a:gd name="T2" fmla="*/ 277906 w 1165412"/>
                    <a:gd name="T3" fmla="*/ 277906 h 573741"/>
                    <a:gd name="T4" fmla="*/ 528918 w 1165412"/>
                    <a:gd name="T5" fmla="*/ 233082 h 573741"/>
                    <a:gd name="T6" fmla="*/ 968189 w 1165412"/>
                    <a:gd name="T7" fmla="*/ 152400 h 573741"/>
                    <a:gd name="T8" fmla="*/ 1165412 w 1165412"/>
                    <a:gd name="T9" fmla="*/ 0 h 573741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67" name="フリーフォーム 66">
                  <a:extLst>
                    <a:ext uri="{FF2B5EF4-FFF2-40B4-BE49-F238E27FC236}">
                      <a16:creationId xmlns:a16="http://schemas.microsoft.com/office/drawing/2014/main" id="{5040A50D-EE48-F621-113E-18B12E690C44}"/>
                    </a:ext>
                  </a:extLst>
                </p:cNvPr>
                <p:cNvSpPr/>
                <p:nvPr/>
              </p:nvSpPr>
              <p:spPr bwMode="auto">
                <a:xfrm>
                  <a:off x="6724796" y="3642069"/>
                  <a:ext cx="1165412" cy="573741"/>
                </a:xfrm>
                <a:custGeom>
                  <a:avLst/>
                  <a:gdLst>
                    <a:gd name="connsiteX0" fmla="*/ 0 w 1165412"/>
                    <a:gd name="connsiteY0" fmla="*/ 573741 h 573741"/>
                    <a:gd name="connsiteX1" fmla="*/ 277906 w 1165412"/>
                    <a:gd name="connsiteY1" fmla="*/ 277906 h 573741"/>
                    <a:gd name="connsiteX2" fmla="*/ 528918 w 1165412"/>
                    <a:gd name="connsiteY2" fmla="*/ 233082 h 573741"/>
                    <a:gd name="connsiteX3" fmla="*/ 968189 w 1165412"/>
                    <a:gd name="connsiteY3" fmla="*/ 152400 h 573741"/>
                    <a:gd name="connsiteX4" fmla="*/ 1165412 w 1165412"/>
                    <a:gd name="connsiteY4" fmla="*/ 0 h 573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3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17" name="グループ化 275">
                <a:extLst>
                  <a:ext uri="{FF2B5EF4-FFF2-40B4-BE49-F238E27FC236}">
                    <a16:creationId xmlns:a16="http://schemas.microsoft.com/office/drawing/2014/main" id="{C88DEA6C-BEE0-7929-7E8E-27E83B8985A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559718" y="4805975"/>
                <a:ext cx="373794" cy="927508"/>
                <a:chOff x="8189975" y="1357391"/>
                <a:chExt cx="404371" cy="1308847"/>
              </a:xfrm>
            </p:grpSpPr>
            <p:sp>
              <p:nvSpPr>
                <p:cNvPr id="64" name="フリーフォーム 198">
                  <a:extLst>
                    <a:ext uri="{FF2B5EF4-FFF2-40B4-BE49-F238E27FC236}">
                      <a16:creationId xmlns:a16="http://schemas.microsoft.com/office/drawing/2014/main" id="{BBAF3914-7DC8-6D3C-4A8A-0A2C8808480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189975" y="1357391"/>
                  <a:ext cx="404371" cy="1308847"/>
                </a:xfrm>
                <a:custGeom>
                  <a:avLst/>
                  <a:gdLst>
                    <a:gd name="T0" fmla="*/ 44824 w 404371"/>
                    <a:gd name="T1" fmla="*/ 0 h 1308847"/>
                    <a:gd name="T2" fmla="*/ 313765 w 404371"/>
                    <a:gd name="T3" fmla="*/ 394447 h 1308847"/>
                    <a:gd name="T4" fmla="*/ 403412 w 404371"/>
                    <a:gd name="T5" fmla="*/ 681318 h 1308847"/>
                    <a:gd name="T6" fmla="*/ 349624 w 404371"/>
                    <a:gd name="T7" fmla="*/ 914400 h 1308847"/>
                    <a:gd name="T8" fmla="*/ 179294 w 404371"/>
                    <a:gd name="T9" fmla="*/ 1066800 h 1308847"/>
                    <a:gd name="T10" fmla="*/ 0 w 404371"/>
                    <a:gd name="T11" fmla="*/ 1308847 h 1308847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0" t="0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65" name="フリーフォーム 64">
                  <a:extLst>
                    <a:ext uri="{FF2B5EF4-FFF2-40B4-BE49-F238E27FC236}">
                      <a16:creationId xmlns:a16="http://schemas.microsoft.com/office/drawing/2014/main" id="{4230EB4C-771C-9C96-AB53-8A23EE9A976E}"/>
                    </a:ext>
                  </a:extLst>
                </p:cNvPr>
                <p:cNvSpPr/>
                <p:nvPr/>
              </p:nvSpPr>
              <p:spPr bwMode="auto">
                <a:xfrm>
                  <a:off x="8189975" y="1357391"/>
                  <a:ext cx="404371" cy="1308847"/>
                </a:xfrm>
                <a:custGeom>
                  <a:avLst/>
                  <a:gdLst>
                    <a:gd name="connsiteX0" fmla="*/ 44824 w 404371"/>
                    <a:gd name="connsiteY0" fmla="*/ 0 h 1308847"/>
                    <a:gd name="connsiteX1" fmla="*/ 313765 w 404371"/>
                    <a:gd name="connsiteY1" fmla="*/ 394447 h 1308847"/>
                    <a:gd name="connsiteX2" fmla="*/ 403412 w 404371"/>
                    <a:gd name="connsiteY2" fmla="*/ 681318 h 1308847"/>
                    <a:gd name="connsiteX3" fmla="*/ 349624 w 404371"/>
                    <a:gd name="connsiteY3" fmla="*/ 914400 h 1308847"/>
                    <a:gd name="connsiteX4" fmla="*/ 179294 w 404371"/>
                    <a:gd name="connsiteY4" fmla="*/ 1066800 h 1308847"/>
                    <a:gd name="connsiteX5" fmla="*/ 0 w 404371"/>
                    <a:gd name="connsiteY5" fmla="*/ 1308847 h 130884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18" name="グループ化 276">
                <a:extLst>
                  <a:ext uri="{FF2B5EF4-FFF2-40B4-BE49-F238E27FC236}">
                    <a16:creationId xmlns:a16="http://schemas.microsoft.com/office/drawing/2014/main" id="{398D2F38-E0AE-6E35-7A55-501560F697F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10503058">
                <a:off x="7451055" y="4929162"/>
                <a:ext cx="395674" cy="947435"/>
                <a:chOff x="5350165" y="1120588"/>
                <a:chExt cx="428041" cy="1336966"/>
              </a:xfrm>
            </p:grpSpPr>
            <p:sp>
              <p:nvSpPr>
                <p:cNvPr id="62" name="フリーフォーム 196">
                  <a:extLst>
                    <a:ext uri="{FF2B5EF4-FFF2-40B4-BE49-F238E27FC236}">
                      <a16:creationId xmlns:a16="http://schemas.microsoft.com/office/drawing/2014/main" id="{E1AE1B42-F941-7882-4160-FBD0B9C4C08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0165" y="1120588"/>
                  <a:ext cx="423732" cy="1335741"/>
                </a:xfrm>
                <a:custGeom>
                  <a:avLst/>
                  <a:gdLst>
                    <a:gd name="T0" fmla="*/ 136235 w 423732"/>
                    <a:gd name="T1" fmla="*/ 0 h 1335741"/>
                    <a:gd name="T2" fmla="*/ 360353 w 423732"/>
                    <a:gd name="T3" fmla="*/ 233083 h 1335741"/>
                    <a:gd name="T4" fmla="*/ 423106 w 423732"/>
                    <a:gd name="T5" fmla="*/ 430306 h 1335741"/>
                    <a:gd name="T6" fmla="*/ 333459 w 423732"/>
                    <a:gd name="T7" fmla="*/ 546847 h 1335741"/>
                    <a:gd name="T8" fmla="*/ 73482 w 423732"/>
                    <a:gd name="T9" fmla="*/ 788894 h 1335741"/>
                    <a:gd name="T10" fmla="*/ 1764 w 423732"/>
                    <a:gd name="T11" fmla="*/ 1075765 h 1335741"/>
                    <a:gd name="T12" fmla="*/ 127270 w 423732"/>
                    <a:gd name="T13" fmla="*/ 1335741 h 133574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682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63" name="フリーフォーム 62">
                  <a:extLst>
                    <a:ext uri="{FF2B5EF4-FFF2-40B4-BE49-F238E27FC236}">
                      <a16:creationId xmlns:a16="http://schemas.microsoft.com/office/drawing/2014/main" id="{94C7FF86-1903-B024-AA24-11A53EC0406D}"/>
                    </a:ext>
                  </a:extLst>
                </p:cNvPr>
                <p:cNvSpPr/>
                <p:nvPr/>
              </p:nvSpPr>
              <p:spPr bwMode="auto">
                <a:xfrm>
                  <a:off x="5354474" y="1121813"/>
                  <a:ext cx="423732" cy="1335741"/>
                </a:xfrm>
                <a:custGeom>
                  <a:avLst/>
                  <a:gdLst>
                    <a:gd name="connsiteX0" fmla="*/ 136235 w 423732"/>
                    <a:gd name="connsiteY0" fmla="*/ 0 h 1335741"/>
                    <a:gd name="connsiteX1" fmla="*/ 360353 w 423732"/>
                    <a:gd name="connsiteY1" fmla="*/ 233083 h 1335741"/>
                    <a:gd name="connsiteX2" fmla="*/ 423106 w 423732"/>
                    <a:gd name="connsiteY2" fmla="*/ 430306 h 1335741"/>
                    <a:gd name="connsiteX3" fmla="*/ 333459 w 423732"/>
                    <a:gd name="connsiteY3" fmla="*/ 546847 h 1335741"/>
                    <a:gd name="connsiteX4" fmla="*/ 73482 w 423732"/>
                    <a:gd name="connsiteY4" fmla="*/ 788894 h 1335741"/>
                    <a:gd name="connsiteX5" fmla="*/ 1764 w 423732"/>
                    <a:gd name="connsiteY5" fmla="*/ 1075765 h 1335741"/>
                    <a:gd name="connsiteX6" fmla="*/ 127270 w 423732"/>
                    <a:gd name="connsiteY6" fmla="*/ 1335741 h 1335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46050" cap="flat" cmpd="sng" algn="ctr">
                  <a:gradFill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19" name="グループ化 277">
                <a:extLst>
                  <a:ext uri="{FF2B5EF4-FFF2-40B4-BE49-F238E27FC236}">
                    <a16:creationId xmlns:a16="http://schemas.microsoft.com/office/drawing/2014/main" id="{F8C73A05-9335-313D-3461-6FBBFAEA14D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7021390" y="4989293"/>
                <a:ext cx="373795" cy="928952"/>
                <a:chOff x="5477181" y="4771234"/>
                <a:chExt cx="404372" cy="1310884"/>
              </a:xfrm>
            </p:grpSpPr>
            <p:sp>
              <p:nvSpPr>
                <p:cNvPr id="60" name="フリーフォーム 194">
                  <a:extLst>
                    <a:ext uri="{FF2B5EF4-FFF2-40B4-BE49-F238E27FC236}">
                      <a16:creationId xmlns:a16="http://schemas.microsoft.com/office/drawing/2014/main" id="{4B90C99A-B70F-F941-3256-B421C4C541B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-2542646">
                  <a:off x="5477181" y="4771234"/>
                  <a:ext cx="404371" cy="1308847"/>
                </a:xfrm>
                <a:custGeom>
                  <a:avLst/>
                  <a:gdLst>
                    <a:gd name="T0" fmla="*/ 44824 w 404371"/>
                    <a:gd name="T1" fmla="*/ 0 h 1308847"/>
                    <a:gd name="T2" fmla="*/ 313765 w 404371"/>
                    <a:gd name="T3" fmla="*/ 394447 h 1308847"/>
                    <a:gd name="T4" fmla="*/ 403412 w 404371"/>
                    <a:gd name="T5" fmla="*/ 681318 h 1308847"/>
                    <a:gd name="T6" fmla="*/ 349624 w 404371"/>
                    <a:gd name="T7" fmla="*/ 914400 h 1308847"/>
                    <a:gd name="T8" fmla="*/ 179294 w 404371"/>
                    <a:gd name="T9" fmla="*/ 1066800 h 1308847"/>
                    <a:gd name="T10" fmla="*/ 0 w 404371"/>
                    <a:gd name="T11" fmla="*/ 1308847 h 1308847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0" t="0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61" name="フリーフォーム 60">
                  <a:extLst>
                    <a:ext uri="{FF2B5EF4-FFF2-40B4-BE49-F238E27FC236}">
                      <a16:creationId xmlns:a16="http://schemas.microsoft.com/office/drawing/2014/main" id="{B4C41D1E-69E6-FE81-5BA9-33E5AB6D7656}"/>
                    </a:ext>
                  </a:extLst>
                </p:cNvPr>
                <p:cNvSpPr/>
                <p:nvPr/>
              </p:nvSpPr>
              <p:spPr bwMode="auto">
                <a:xfrm rot="19057354">
                  <a:off x="5477182" y="4773271"/>
                  <a:ext cx="404371" cy="1308847"/>
                </a:xfrm>
                <a:custGeom>
                  <a:avLst/>
                  <a:gdLst>
                    <a:gd name="connsiteX0" fmla="*/ 44824 w 404371"/>
                    <a:gd name="connsiteY0" fmla="*/ 0 h 1308847"/>
                    <a:gd name="connsiteX1" fmla="*/ 313765 w 404371"/>
                    <a:gd name="connsiteY1" fmla="*/ 394447 h 1308847"/>
                    <a:gd name="connsiteX2" fmla="*/ 403412 w 404371"/>
                    <a:gd name="connsiteY2" fmla="*/ 681318 h 1308847"/>
                    <a:gd name="connsiteX3" fmla="*/ 349624 w 404371"/>
                    <a:gd name="connsiteY3" fmla="*/ 914400 h 1308847"/>
                    <a:gd name="connsiteX4" fmla="*/ 179294 w 404371"/>
                    <a:gd name="connsiteY4" fmla="*/ 1066800 h 1308847"/>
                    <a:gd name="connsiteX5" fmla="*/ 0 w 404371"/>
                    <a:gd name="connsiteY5" fmla="*/ 1308847 h 130884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404371" h="1308847">
                      <a:moveTo>
                        <a:pt x="44824" y="0"/>
                      </a:moveTo>
                      <a:cubicBezTo>
                        <a:pt x="149412" y="140447"/>
                        <a:pt x="254000" y="280894"/>
                        <a:pt x="313765" y="394447"/>
                      </a:cubicBezTo>
                      <a:cubicBezTo>
                        <a:pt x="373530" y="508000"/>
                        <a:pt x="397436" y="594659"/>
                        <a:pt x="403412" y="681318"/>
                      </a:cubicBezTo>
                      <a:cubicBezTo>
                        <a:pt x="409388" y="767977"/>
                        <a:pt x="386977" y="850153"/>
                        <a:pt x="349624" y="914400"/>
                      </a:cubicBezTo>
                      <a:cubicBezTo>
                        <a:pt x="312271" y="978647"/>
                        <a:pt x="237565" y="1001059"/>
                        <a:pt x="179294" y="1066800"/>
                      </a:cubicBezTo>
                      <a:cubicBezTo>
                        <a:pt x="121023" y="1132541"/>
                        <a:pt x="60511" y="1220694"/>
                        <a:pt x="0" y="1308847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50000">
                        <a:srgbClr val="0070C0"/>
                      </a:gs>
                      <a:gs pos="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chemeClr val="accent5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20" name="グループ化 278">
                <a:extLst>
                  <a:ext uri="{FF2B5EF4-FFF2-40B4-BE49-F238E27FC236}">
                    <a16:creationId xmlns:a16="http://schemas.microsoft.com/office/drawing/2014/main" id="{AA8714F4-1F4C-91E2-E9A6-3A49A08E753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728872">
                <a:off x="7160306" y="4874690"/>
                <a:ext cx="395674" cy="947435"/>
                <a:chOff x="5350165" y="1120588"/>
                <a:chExt cx="428041" cy="1336966"/>
              </a:xfrm>
            </p:grpSpPr>
            <p:sp>
              <p:nvSpPr>
                <p:cNvPr id="58" name="フリーフォーム 192">
                  <a:extLst>
                    <a:ext uri="{FF2B5EF4-FFF2-40B4-BE49-F238E27FC236}">
                      <a16:creationId xmlns:a16="http://schemas.microsoft.com/office/drawing/2014/main" id="{4141EC21-9C5A-6A1E-512F-83C627E5846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0165" y="1120588"/>
                  <a:ext cx="423732" cy="1335741"/>
                </a:xfrm>
                <a:custGeom>
                  <a:avLst/>
                  <a:gdLst>
                    <a:gd name="T0" fmla="*/ 136235 w 423732"/>
                    <a:gd name="T1" fmla="*/ 0 h 1335741"/>
                    <a:gd name="T2" fmla="*/ 360353 w 423732"/>
                    <a:gd name="T3" fmla="*/ 233083 h 1335741"/>
                    <a:gd name="T4" fmla="*/ 423106 w 423732"/>
                    <a:gd name="T5" fmla="*/ 430306 h 1335741"/>
                    <a:gd name="T6" fmla="*/ 333459 w 423732"/>
                    <a:gd name="T7" fmla="*/ 546847 h 1335741"/>
                    <a:gd name="T8" fmla="*/ 73482 w 423732"/>
                    <a:gd name="T9" fmla="*/ 788894 h 1335741"/>
                    <a:gd name="T10" fmla="*/ 1764 w 423732"/>
                    <a:gd name="T11" fmla="*/ 1075765 h 1335741"/>
                    <a:gd name="T12" fmla="*/ 127270 w 423732"/>
                    <a:gd name="T13" fmla="*/ 1335741 h 133574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682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59" name="フリーフォーム 58">
                  <a:extLst>
                    <a:ext uri="{FF2B5EF4-FFF2-40B4-BE49-F238E27FC236}">
                      <a16:creationId xmlns:a16="http://schemas.microsoft.com/office/drawing/2014/main" id="{D4E3FCD0-2923-FC4B-55E8-DF3130582A84}"/>
                    </a:ext>
                  </a:extLst>
                </p:cNvPr>
                <p:cNvSpPr/>
                <p:nvPr/>
              </p:nvSpPr>
              <p:spPr bwMode="auto">
                <a:xfrm>
                  <a:off x="5354474" y="1121813"/>
                  <a:ext cx="423732" cy="1335741"/>
                </a:xfrm>
                <a:custGeom>
                  <a:avLst/>
                  <a:gdLst>
                    <a:gd name="connsiteX0" fmla="*/ 136235 w 423732"/>
                    <a:gd name="connsiteY0" fmla="*/ 0 h 1335741"/>
                    <a:gd name="connsiteX1" fmla="*/ 360353 w 423732"/>
                    <a:gd name="connsiteY1" fmla="*/ 233083 h 1335741"/>
                    <a:gd name="connsiteX2" fmla="*/ 423106 w 423732"/>
                    <a:gd name="connsiteY2" fmla="*/ 430306 h 1335741"/>
                    <a:gd name="connsiteX3" fmla="*/ 333459 w 423732"/>
                    <a:gd name="connsiteY3" fmla="*/ 546847 h 1335741"/>
                    <a:gd name="connsiteX4" fmla="*/ 73482 w 423732"/>
                    <a:gd name="connsiteY4" fmla="*/ 788894 h 1335741"/>
                    <a:gd name="connsiteX5" fmla="*/ 1764 w 423732"/>
                    <a:gd name="connsiteY5" fmla="*/ 1075765 h 1335741"/>
                    <a:gd name="connsiteX6" fmla="*/ 127270 w 423732"/>
                    <a:gd name="connsiteY6" fmla="*/ 1335741 h 1335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46050" cap="flat" cmpd="sng" algn="ctr">
                  <a:gradFill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21" name="グループ化 279">
                <a:extLst>
                  <a:ext uri="{FF2B5EF4-FFF2-40B4-BE49-F238E27FC236}">
                    <a16:creationId xmlns:a16="http://schemas.microsoft.com/office/drawing/2014/main" id="{FD68648A-DDAF-B08B-283C-A143A94C61F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400000">
                <a:off x="6988190" y="4887317"/>
                <a:ext cx="303330" cy="1235870"/>
                <a:chOff x="5350165" y="1120588"/>
                <a:chExt cx="428041" cy="1336966"/>
              </a:xfrm>
            </p:grpSpPr>
            <p:sp>
              <p:nvSpPr>
                <p:cNvPr id="56" name="フリーフォーム 190">
                  <a:extLst>
                    <a:ext uri="{FF2B5EF4-FFF2-40B4-BE49-F238E27FC236}">
                      <a16:creationId xmlns:a16="http://schemas.microsoft.com/office/drawing/2014/main" id="{523BEFD3-93D6-862B-86F6-BA959D62097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0165" y="1120588"/>
                  <a:ext cx="423732" cy="1335741"/>
                </a:xfrm>
                <a:custGeom>
                  <a:avLst/>
                  <a:gdLst>
                    <a:gd name="T0" fmla="*/ 136235 w 423732"/>
                    <a:gd name="T1" fmla="*/ 0 h 1335741"/>
                    <a:gd name="T2" fmla="*/ 360353 w 423732"/>
                    <a:gd name="T3" fmla="*/ 233083 h 1335741"/>
                    <a:gd name="T4" fmla="*/ 423106 w 423732"/>
                    <a:gd name="T5" fmla="*/ 430306 h 1335741"/>
                    <a:gd name="T6" fmla="*/ 333459 w 423732"/>
                    <a:gd name="T7" fmla="*/ 546847 h 1335741"/>
                    <a:gd name="T8" fmla="*/ 73482 w 423732"/>
                    <a:gd name="T9" fmla="*/ 788894 h 1335741"/>
                    <a:gd name="T10" fmla="*/ 1764 w 423732"/>
                    <a:gd name="T11" fmla="*/ 1075765 h 1335741"/>
                    <a:gd name="T12" fmla="*/ 127270 w 423732"/>
                    <a:gd name="T13" fmla="*/ 1335741 h 133574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682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57" name="フリーフォーム 56">
                  <a:extLst>
                    <a:ext uri="{FF2B5EF4-FFF2-40B4-BE49-F238E27FC236}">
                      <a16:creationId xmlns:a16="http://schemas.microsoft.com/office/drawing/2014/main" id="{1C9A26A8-16FB-407B-A5B3-7ABC02AE41E5}"/>
                    </a:ext>
                  </a:extLst>
                </p:cNvPr>
                <p:cNvSpPr/>
                <p:nvPr/>
              </p:nvSpPr>
              <p:spPr bwMode="auto">
                <a:xfrm>
                  <a:off x="5354474" y="1121813"/>
                  <a:ext cx="423732" cy="1335741"/>
                </a:xfrm>
                <a:custGeom>
                  <a:avLst/>
                  <a:gdLst>
                    <a:gd name="connsiteX0" fmla="*/ 136235 w 423732"/>
                    <a:gd name="connsiteY0" fmla="*/ 0 h 1335741"/>
                    <a:gd name="connsiteX1" fmla="*/ 360353 w 423732"/>
                    <a:gd name="connsiteY1" fmla="*/ 233083 h 1335741"/>
                    <a:gd name="connsiteX2" fmla="*/ 423106 w 423732"/>
                    <a:gd name="connsiteY2" fmla="*/ 430306 h 1335741"/>
                    <a:gd name="connsiteX3" fmla="*/ 333459 w 423732"/>
                    <a:gd name="connsiteY3" fmla="*/ 546847 h 1335741"/>
                    <a:gd name="connsiteX4" fmla="*/ 73482 w 423732"/>
                    <a:gd name="connsiteY4" fmla="*/ 788894 h 1335741"/>
                    <a:gd name="connsiteX5" fmla="*/ 1764 w 423732"/>
                    <a:gd name="connsiteY5" fmla="*/ 1075765 h 1335741"/>
                    <a:gd name="connsiteX6" fmla="*/ 127270 w 423732"/>
                    <a:gd name="connsiteY6" fmla="*/ 1335741 h 1335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23732" h="1335741">
                      <a:moveTo>
                        <a:pt x="136235" y="0"/>
                      </a:moveTo>
                      <a:cubicBezTo>
                        <a:pt x="224388" y="80682"/>
                        <a:pt x="312541" y="161365"/>
                        <a:pt x="360353" y="233083"/>
                      </a:cubicBezTo>
                      <a:cubicBezTo>
                        <a:pt x="408165" y="304801"/>
                        <a:pt x="427588" y="378012"/>
                        <a:pt x="423106" y="430306"/>
                      </a:cubicBezTo>
                      <a:cubicBezTo>
                        <a:pt x="418624" y="482600"/>
                        <a:pt x="391730" y="487082"/>
                        <a:pt x="333459" y="546847"/>
                      </a:cubicBezTo>
                      <a:cubicBezTo>
                        <a:pt x="275188" y="606612"/>
                        <a:pt x="128764" y="700741"/>
                        <a:pt x="73482" y="788894"/>
                      </a:cubicBezTo>
                      <a:cubicBezTo>
                        <a:pt x="18200" y="877047"/>
                        <a:pt x="-7201" y="984624"/>
                        <a:pt x="1764" y="1075765"/>
                      </a:cubicBezTo>
                      <a:cubicBezTo>
                        <a:pt x="10729" y="1166906"/>
                        <a:pt x="68999" y="1251323"/>
                        <a:pt x="127270" y="1335741"/>
                      </a:cubicBezTo>
                    </a:path>
                  </a:pathLst>
                </a:custGeom>
                <a:noFill/>
                <a:ln w="146050" cap="flat" cmpd="sng" algn="ctr">
                  <a:gradFill>
                    <a:gsLst>
                      <a:gs pos="0">
                        <a:srgbClr val="0070C0"/>
                      </a:gs>
                      <a:gs pos="50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22" name="グループ化 280">
                <a:extLst>
                  <a:ext uri="{FF2B5EF4-FFF2-40B4-BE49-F238E27FC236}">
                    <a16:creationId xmlns:a16="http://schemas.microsoft.com/office/drawing/2014/main" id="{C27029D5-93B3-2D7F-D5C9-993ED659D1E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2795869">
                <a:off x="6613231" y="5082482"/>
                <a:ext cx="1003515" cy="530358"/>
                <a:chOff x="6724796" y="3642069"/>
                <a:chExt cx="1165412" cy="573742"/>
              </a:xfrm>
            </p:grpSpPr>
            <p:sp>
              <p:nvSpPr>
                <p:cNvPr id="54" name="フリーフォーム 188">
                  <a:extLst>
                    <a:ext uri="{FF2B5EF4-FFF2-40B4-BE49-F238E27FC236}">
                      <a16:creationId xmlns:a16="http://schemas.microsoft.com/office/drawing/2014/main" id="{6C457488-E9A6-607D-B3AE-6919D196D4D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24796" y="3642070"/>
                  <a:ext cx="1165412" cy="573741"/>
                </a:xfrm>
                <a:custGeom>
                  <a:avLst/>
                  <a:gdLst>
                    <a:gd name="T0" fmla="*/ 0 w 1165412"/>
                    <a:gd name="T1" fmla="*/ 573741 h 573741"/>
                    <a:gd name="T2" fmla="*/ 277906 w 1165412"/>
                    <a:gd name="T3" fmla="*/ 277906 h 573741"/>
                    <a:gd name="T4" fmla="*/ 528918 w 1165412"/>
                    <a:gd name="T5" fmla="*/ 233082 h 573741"/>
                    <a:gd name="T6" fmla="*/ 968189 w 1165412"/>
                    <a:gd name="T7" fmla="*/ 152400 h 573741"/>
                    <a:gd name="T8" fmla="*/ 1165412 w 1165412"/>
                    <a:gd name="T9" fmla="*/ 0 h 573741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55" name="フリーフォーム 54">
                  <a:extLst>
                    <a:ext uri="{FF2B5EF4-FFF2-40B4-BE49-F238E27FC236}">
                      <a16:creationId xmlns:a16="http://schemas.microsoft.com/office/drawing/2014/main" id="{46B249B5-F1A5-B900-2053-E219B9402964}"/>
                    </a:ext>
                  </a:extLst>
                </p:cNvPr>
                <p:cNvSpPr/>
                <p:nvPr/>
              </p:nvSpPr>
              <p:spPr bwMode="auto">
                <a:xfrm>
                  <a:off x="6724796" y="3642069"/>
                  <a:ext cx="1165412" cy="573741"/>
                </a:xfrm>
                <a:custGeom>
                  <a:avLst/>
                  <a:gdLst>
                    <a:gd name="connsiteX0" fmla="*/ 0 w 1165412"/>
                    <a:gd name="connsiteY0" fmla="*/ 573741 h 573741"/>
                    <a:gd name="connsiteX1" fmla="*/ 277906 w 1165412"/>
                    <a:gd name="connsiteY1" fmla="*/ 277906 h 573741"/>
                    <a:gd name="connsiteX2" fmla="*/ 528918 w 1165412"/>
                    <a:gd name="connsiteY2" fmla="*/ 233082 h 573741"/>
                    <a:gd name="connsiteX3" fmla="*/ 968189 w 1165412"/>
                    <a:gd name="connsiteY3" fmla="*/ 152400 h 573741"/>
                    <a:gd name="connsiteX4" fmla="*/ 1165412 w 1165412"/>
                    <a:gd name="connsiteY4" fmla="*/ 0 h 573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3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23" name="グループ化 281">
                <a:extLst>
                  <a:ext uri="{FF2B5EF4-FFF2-40B4-BE49-F238E27FC236}">
                    <a16:creationId xmlns:a16="http://schemas.microsoft.com/office/drawing/2014/main" id="{A71E6C7B-F8E1-617E-B443-6DC96EB91C5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6791888">
                <a:off x="7003759" y="5056618"/>
                <a:ext cx="1003515" cy="530358"/>
                <a:chOff x="6724796" y="3642069"/>
                <a:chExt cx="1165412" cy="573742"/>
              </a:xfrm>
            </p:grpSpPr>
            <p:sp>
              <p:nvSpPr>
                <p:cNvPr id="52" name="フリーフォーム 186">
                  <a:extLst>
                    <a:ext uri="{FF2B5EF4-FFF2-40B4-BE49-F238E27FC236}">
                      <a16:creationId xmlns:a16="http://schemas.microsoft.com/office/drawing/2014/main" id="{E21A77A8-AA19-E4D0-2F89-25A5E0B1696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24796" y="3642070"/>
                  <a:ext cx="1165412" cy="573741"/>
                </a:xfrm>
                <a:custGeom>
                  <a:avLst/>
                  <a:gdLst>
                    <a:gd name="T0" fmla="*/ 0 w 1165412"/>
                    <a:gd name="T1" fmla="*/ 573741 h 573741"/>
                    <a:gd name="T2" fmla="*/ 277906 w 1165412"/>
                    <a:gd name="T3" fmla="*/ 277906 h 573741"/>
                    <a:gd name="T4" fmla="*/ 528918 w 1165412"/>
                    <a:gd name="T5" fmla="*/ 233082 h 573741"/>
                    <a:gd name="T6" fmla="*/ 968189 w 1165412"/>
                    <a:gd name="T7" fmla="*/ 152400 h 573741"/>
                    <a:gd name="T8" fmla="*/ 1165412 w 1165412"/>
                    <a:gd name="T9" fmla="*/ 0 h 573741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65100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  <p:sp>
              <p:nvSpPr>
                <p:cNvPr id="53" name="フリーフォーム 52">
                  <a:extLst>
                    <a:ext uri="{FF2B5EF4-FFF2-40B4-BE49-F238E27FC236}">
                      <a16:creationId xmlns:a16="http://schemas.microsoft.com/office/drawing/2014/main" id="{0CB80E77-F51C-CD83-886D-60E85DAB53B2}"/>
                    </a:ext>
                  </a:extLst>
                </p:cNvPr>
                <p:cNvSpPr/>
                <p:nvPr/>
              </p:nvSpPr>
              <p:spPr bwMode="auto">
                <a:xfrm>
                  <a:off x="6724796" y="3642069"/>
                  <a:ext cx="1165412" cy="573741"/>
                </a:xfrm>
                <a:custGeom>
                  <a:avLst/>
                  <a:gdLst>
                    <a:gd name="connsiteX0" fmla="*/ 0 w 1165412"/>
                    <a:gd name="connsiteY0" fmla="*/ 573741 h 573741"/>
                    <a:gd name="connsiteX1" fmla="*/ 277906 w 1165412"/>
                    <a:gd name="connsiteY1" fmla="*/ 277906 h 573741"/>
                    <a:gd name="connsiteX2" fmla="*/ 528918 w 1165412"/>
                    <a:gd name="connsiteY2" fmla="*/ 233082 h 573741"/>
                    <a:gd name="connsiteX3" fmla="*/ 968189 w 1165412"/>
                    <a:gd name="connsiteY3" fmla="*/ 152400 h 573741"/>
                    <a:gd name="connsiteX4" fmla="*/ 1165412 w 1165412"/>
                    <a:gd name="connsiteY4" fmla="*/ 0 h 5737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65412" h="573741">
                      <a:moveTo>
                        <a:pt x="0" y="573741"/>
                      </a:moveTo>
                      <a:cubicBezTo>
                        <a:pt x="94876" y="454211"/>
                        <a:pt x="189753" y="334682"/>
                        <a:pt x="277906" y="277906"/>
                      </a:cubicBezTo>
                      <a:cubicBezTo>
                        <a:pt x="366059" y="221130"/>
                        <a:pt x="528918" y="233082"/>
                        <a:pt x="528918" y="233082"/>
                      </a:cubicBezTo>
                      <a:cubicBezTo>
                        <a:pt x="643965" y="212164"/>
                        <a:pt x="862107" y="191247"/>
                        <a:pt x="968189" y="152400"/>
                      </a:cubicBezTo>
                      <a:cubicBezTo>
                        <a:pt x="1074271" y="113553"/>
                        <a:pt x="1119841" y="56776"/>
                        <a:pt x="1165412" y="0"/>
                      </a:cubicBezTo>
                    </a:path>
                  </a:pathLst>
                </a:custGeom>
                <a:noFill/>
                <a:ln w="139700" cap="flat" cmpd="sng" algn="ctr">
                  <a:gradFill flip="none" rotWithShape="1">
                    <a:gsLst>
                      <a:gs pos="0">
                        <a:srgbClr val="0070C0"/>
                      </a:gs>
                      <a:gs pos="53000">
                        <a:schemeClr val="accent1">
                          <a:lumMod val="45000"/>
                          <a:lumOff val="55000"/>
                        </a:schemeClr>
                      </a:gs>
                      <a:gs pos="100000">
                        <a:srgbClr val="0070C0"/>
                      </a:gs>
                    </a:gsLst>
                    <a:lin ang="5400000" scaled="1"/>
                    <a:tileRect/>
                  </a:gra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sp>
            <p:nvSpPr>
              <p:cNvPr id="24" name="円/楕円 23">
                <a:extLst>
                  <a:ext uri="{FF2B5EF4-FFF2-40B4-BE49-F238E27FC236}">
                    <a16:creationId xmlns:a16="http://schemas.microsoft.com/office/drawing/2014/main" id="{21ED2D19-C5C5-C9EC-186E-765B58B72B72}"/>
                  </a:ext>
                </a:extLst>
              </p:cNvPr>
              <p:cNvSpPr/>
              <p:nvPr/>
            </p:nvSpPr>
            <p:spPr bwMode="auto">
              <a:xfrm>
                <a:off x="7459332" y="4749769"/>
                <a:ext cx="142482" cy="82841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5" name="円/楕円 24">
                <a:extLst>
                  <a:ext uri="{FF2B5EF4-FFF2-40B4-BE49-F238E27FC236}">
                    <a16:creationId xmlns:a16="http://schemas.microsoft.com/office/drawing/2014/main" id="{EA0D0028-0A91-9251-578F-795742F17B4F}"/>
                  </a:ext>
                </a:extLst>
              </p:cNvPr>
              <p:cNvSpPr/>
              <p:nvPr/>
            </p:nvSpPr>
            <p:spPr bwMode="auto">
              <a:xfrm>
                <a:off x="6506538" y="5677201"/>
                <a:ext cx="142482" cy="82841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6" name="円/楕円 25">
                <a:extLst>
                  <a:ext uri="{FF2B5EF4-FFF2-40B4-BE49-F238E27FC236}">
                    <a16:creationId xmlns:a16="http://schemas.microsoft.com/office/drawing/2014/main" id="{C4ECF05B-08F4-1FBD-217F-40987A2D82E0}"/>
                  </a:ext>
                </a:extLst>
              </p:cNvPr>
              <p:cNvSpPr/>
              <p:nvPr/>
            </p:nvSpPr>
            <p:spPr bwMode="auto">
              <a:xfrm>
                <a:off x="6523080" y="4761893"/>
                <a:ext cx="142482" cy="82841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grpSp>
            <p:nvGrpSpPr>
              <p:cNvPr id="27" name="グループ化 285">
                <a:extLst>
                  <a:ext uri="{FF2B5EF4-FFF2-40B4-BE49-F238E27FC236}">
                    <a16:creationId xmlns:a16="http://schemas.microsoft.com/office/drawing/2014/main" id="{1A3ED6D9-650E-09BA-6738-F5907C45629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934583" y="4785037"/>
                <a:ext cx="521236" cy="984155"/>
                <a:chOff x="2930453" y="4198301"/>
                <a:chExt cx="567025" cy="1335929"/>
              </a:xfrm>
            </p:grpSpPr>
            <p:grpSp>
              <p:nvGrpSpPr>
                <p:cNvPr id="47" name="グループ化 309">
                  <a:extLst>
                    <a:ext uri="{FF2B5EF4-FFF2-40B4-BE49-F238E27FC236}">
                      <a16:creationId xmlns:a16="http://schemas.microsoft.com/office/drawing/2014/main" id="{7A2CBD19-7CCF-BEAE-6379-C4D951D03528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126843">
                  <a:off x="2930453" y="4268074"/>
                  <a:ext cx="406631" cy="1259035"/>
                  <a:chOff x="8189975" y="1357391"/>
                  <a:chExt cx="404371" cy="1308847"/>
                </a:xfrm>
              </p:grpSpPr>
              <p:sp>
                <p:nvSpPr>
                  <p:cNvPr id="50" name="フリーフォーム 184">
                    <a:extLst>
                      <a:ext uri="{FF2B5EF4-FFF2-40B4-BE49-F238E27FC236}">
                        <a16:creationId xmlns:a16="http://schemas.microsoft.com/office/drawing/2014/main" id="{CBB6730D-A3B8-4826-0FEA-ACA26031DAE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51" name="フリーフォーム 50">
                    <a:extLst>
                      <a:ext uri="{FF2B5EF4-FFF2-40B4-BE49-F238E27FC236}">
                        <a16:creationId xmlns:a16="http://schemas.microsoft.com/office/drawing/2014/main" id="{EE60A144-7819-BC62-4F13-5590BBA7E3B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0">
                          <a:srgbClr val="0070C0"/>
                        </a:gs>
                        <a:gs pos="5000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rgbClr val="0070C0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48" name="円/楕円 47">
                  <a:extLst>
                    <a:ext uri="{FF2B5EF4-FFF2-40B4-BE49-F238E27FC236}">
                      <a16:creationId xmlns:a16="http://schemas.microsoft.com/office/drawing/2014/main" id="{34296D99-965C-6176-18A0-6F4094F795F5}"/>
                    </a:ext>
                  </a:extLst>
                </p:cNvPr>
                <p:cNvSpPr/>
                <p:nvPr/>
              </p:nvSpPr>
              <p:spPr bwMode="auto">
                <a:xfrm>
                  <a:off x="3342480" y="5421778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  <p:sp>
              <p:nvSpPr>
                <p:cNvPr id="49" name="円/楕円 48">
                  <a:extLst>
                    <a:ext uri="{FF2B5EF4-FFF2-40B4-BE49-F238E27FC236}">
                      <a16:creationId xmlns:a16="http://schemas.microsoft.com/office/drawing/2014/main" id="{8D363FB0-29C0-4E38-7816-577E6A104519}"/>
                    </a:ext>
                  </a:extLst>
                </p:cNvPr>
                <p:cNvSpPr/>
                <p:nvPr/>
              </p:nvSpPr>
              <p:spPr bwMode="auto">
                <a:xfrm>
                  <a:off x="3116359" y="4198301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sp>
            <p:nvSpPr>
              <p:cNvPr id="28" name="円/楕円 27">
                <a:extLst>
                  <a:ext uri="{FF2B5EF4-FFF2-40B4-BE49-F238E27FC236}">
                    <a16:creationId xmlns:a16="http://schemas.microsoft.com/office/drawing/2014/main" id="{FD0FCE9E-52AF-8EC1-B044-C2EF375AF0D2}"/>
                  </a:ext>
                </a:extLst>
              </p:cNvPr>
              <p:cNvSpPr/>
              <p:nvPr/>
            </p:nvSpPr>
            <p:spPr bwMode="auto">
              <a:xfrm>
                <a:off x="7415854" y="5804721"/>
                <a:ext cx="142482" cy="82841"/>
              </a:xfrm>
              <a:prstGeom prst="ellipse">
                <a:avLst/>
              </a:prstGeom>
              <a:solidFill>
                <a:schemeClr val="accent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scene3d>
                <a:camera prst="orthographicFront">
                  <a:rot lat="0" lon="0" rev="11400000"/>
                </a:camera>
                <a:lightRig rig="threePt" dir="t"/>
              </a:scene3d>
            </p:spPr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atin typeface="Calibri" panose="020F0502020204030204" pitchFamily="34" charset="0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9" name="フリーフォーム 163">
                <a:extLst>
                  <a:ext uri="{FF2B5EF4-FFF2-40B4-BE49-F238E27FC236}">
                    <a16:creationId xmlns:a16="http://schemas.microsoft.com/office/drawing/2014/main" id="{9EFEAC23-C6BF-AABF-BAB0-592BBE8332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94381" y="5179273"/>
                <a:ext cx="107729" cy="44469"/>
              </a:xfrm>
              <a:custGeom>
                <a:avLst/>
                <a:gdLst>
                  <a:gd name="T0" fmla="*/ 67210 w 116542"/>
                  <a:gd name="T1" fmla="*/ 5632 h 62753"/>
                  <a:gd name="T2" fmla="*/ 0 w 116542"/>
                  <a:gd name="T3" fmla="*/ 0 h 6275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16542" h="62753">
                    <a:moveTo>
                      <a:pt x="116542" y="62753"/>
                    </a:moveTo>
                    <a:cubicBezTo>
                      <a:pt x="40342" y="29882"/>
                      <a:pt x="59765" y="43329"/>
                      <a:pt x="0" y="0"/>
                    </a:cubicBezTo>
                  </a:path>
                </a:pathLst>
              </a:custGeom>
              <a:noFill/>
              <a:ln w="15875" cap="flat" cmpd="sng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anchor="ctr"/>
              <a:lstStyle/>
              <a:p>
                <a:endParaRPr lang="ja-JP" altLang="en-US"/>
              </a:p>
            </p:txBody>
          </p:sp>
          <p:sp>
            <p:nvSpPr>
              <p:cNvPr id="30" name="フリーフォーム 164">
                <a:extLst>
                  <a:ext uri="{FF2B5EF4-FFF2-40B4-BE49-F238E27FC236}">
                    <a16:creationId xmlns:a16="http://schemas.microsoft.com/office/drawing/2014/main" id="{3D268D13-6095-5E42-7C7A-991B8F63FB26}"/>
                  </a:ext>
                </a:extLst>
              </p:cNvPr>
              <p:cNvSpPr>
                <a:spLocks/>
              </p:cNvSpPr>
              <p:nvPr/>
            </p:nvSpPr>
            <p:spPr bwMode="auto">
              <a:xfrm rot="-1178287">
                <a:off x="7298264" y="4830991"/>
                <a:ext cx="133526" cy="25259"/>
              </a:xfrm>
              <a:custGeom>
                <a:avLst/>
                <a:gdLst>
                  <a:gd name="T0" fmla="*/ 211268288 w 39116"/>
                  <a:gd name="T1" fmla="*/ 1117529 h 13431"/>
                  <a:gd name="T2" fmla="*/ 0 w 39116"/>
                  <a:gd name="T3" fmla="*/ 0 h 13431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39116" h="13431">
                    <a:moveTo>
                      <a:pt x="39116" y="13431"/>
                    </a:moveTo>
                    <a:lnTo>
                      <a:pt x="0" y="0"/>
                    </a:lnTo>
                  </a:path>
                </a:pathLst>
              </a:custGeom>
              <a:noFill/>
              <a:ln w="15875" cap="flat" cmpd="sng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anchor="ctr"/>
              <a:lstStyle/>
              <a:p>
                <a:endParaRPr lang="ja-JP" altLang="en-US"/>
              </a:p>
            </p:txBody>
          </p:sp>
          <p:grpSp>
            <p:nvGrpSpPr>
              <p:cNvPr id="31" name="グループ化 289">
                <a:extLst>
                  <a:ext uri="{FF2B5EF4-FFF2-40B4-BE49-F238E27FC236}">
                    <a16:creationId xmlns:a16="http://schemas.microsoft.com/office/drawing/2014/main" id="{9E211518-FF6E-6C6B-DD47-5C5934B65E7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807826">
                <a:off x="7127627" y="4477632"/>
                <a:ext cx="421343" cy="1243477"/>
                <a:chOff x="1017959" y="4218171"/>
                <a:chExt cx="571947" cy="1352713"/>
              </a:xfrm>
            </p:grpSpPr>
            <p:grpSp>
              <p:nvGrpSpPr>
                <p:cNvPr id="42" name="グループ化 304">
                  <a:extLst>
                    <a:ext uri="{FF2B5EF4-FFF2-40B4-BE49-F238E27FC236}">
                      <a16:creationId xmlns:a16="http://schemas.microsoft.com/office/drawing/2014/main" id="{8F6D223C-8143-52F7-4555-2ACBABAA264C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-10337146">
                  <a:off x="1017959" y="4248206"/>
                  <a:ext cx="406631" cy="1259035"/>
                  <a:chOff x="8189975" y="1357391"/>
                  <a:chExt cx="404371" cy="1308847"/>
                </a:xfrm>
              </p:grpSpPr>
              <p:sp>
                <p:nvSpPr>
                  <p:cNvPr id="45" name="フリーフォーム 179">
                    <a:extLst>
                      <a:ext uri="{FF2B5EF4-FFF2-40B4-BE49-F238E27FC236}">
                        <a16:creationId xmlns:a16="http://schemas.microsoft.com/office/drawing/2014/main" id="{70EF3E9B-702A-2486-CCFD-BF6EAFDF8BB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46" name="フリーフォーム 45">
                    <a:extLst>
                      <a:ext uri="{FF2B5EF4-FFF2-40B4-BE49-F238E27FC236}">
                        <a16:creationId xmlns:a16="http://schemas.microsoft.com/office/drawing/2014/main" id="{FC440BB2-0538-43D6-7E7A-CADA840A4E6B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0">
                          <a:srgbClr val="0070C0"/>
                        </a:gs>
                        <a:gs pos="5000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rgbClr val="0070C0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43" name="円/楕円 42">
                  <a:extLst>
                    <a:ext uri="{FF2B5EF4-FFF2-40B4-BE49-F238E27FC236}">
                      <a16:creationId xmlns:a16="http://schemas.microsoft.com/office/drawing/2014/main" id="{93F2F268-9EFB-F8C7-4FDF-F36E7E0CAE34}"/>
                    </a:ext>
                  </a:extLst>
                </p:cNvPr>
                <p:cNvSpPr/>
                <p:nvPr/>
              </p:nvSpPr>
              <p:spPr bwMode="auto">
                <a:xfrm>
                  <a:off x="1413308" y="4218171"/>
                  <a:ext cx="176598" cy="12842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  <p:sp>
              <p:nvSpPr>
                <p:cNvPr id="44" name="円/楕円 43">
                  <a:extLst>
                    <a:ext uri="{FF2B5EF4-FFF2-40B4-BE49-F238E27FC236}">
                      <a16:creationId xmlns:a16="http://schemas.microsoft.com/office/drawing/2014/main" id="{E37A5CD6-3122-BFFF-9724-118C499AC775}"/>
                    </a:ext>
                  </a:extLst>
                </p:cNvPr>
                <p:cNvSpPr/>
                <p:nvPr/>
              </p:nvSpPr>
              <p:spPr bwMode="auto">
                <a:xfrm>
                  <a:off x="1216003" y="5458432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14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  <p:grpSp>
            <p:nvGrpSpPr>
              <p:cNvPr id="32" name="グループ化 290">
                <a:extLst>
                  <a:ext uri="{FF2B5EF4-FFF2-40B4-BE49-F238E27FC236}">
                    <a16:creationId xmlns:a16="http://schemas.microsoft.com/office/drawing/2014/main" id="{E4747975-EED6-F688-1D7B-4EC242AC42B0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6162344">
                <a:off x="6964624" y="5142935"/>
                <a:ext cx="977903" cy="402090"/>
                <a:chOff x="2554579" y="6031689"/>
                <a:chExt cx="1327443" cy="437412"/>
              </a:xfrm>
            </p:grpSpPr>
            <p:grpSp>
              <p:nvGrpSpPr>
                <p:cNvPr id="38" name="グループ化 300">
                  <a:extLst>
                    <a:ext uri="{FF2B5EF4-FFF2-40B4-BE49-F238E27FC236}">
                      <a16:creationId xmlns:a16="http://schemas.microsoft.com/office/drawing/2014/main" id="{69B3DA7D-7973-DEA3-3F49-458E1D085BDA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6134345">
                  <a:off x="3028427" y="5567075"/>
                  <a:ext cx="388982" cy="1318209"/>
                  <a:chOff x="5477181" y="4771234"/>
                  <a:chExt cx="404372" cy="1310884"/>
                </a:xfrm>
              </p:grpSpPr>
              <p:sp>
                <p:nvSpPr>
                  <p:cNvPr id="40" name="フリーフォーム 174">
                    <a:extLst>
                      <a:ext uri="{FF2B5EF4-FFF2-40B4-BE49-F238E27FC236}">
                        <a16:creationId xmlns:a16="http://schemas.microsoft.com/office/drawing/2014/main" id="{26A20BB9-B91A-3971-A40C-1C8DAEF2AA1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 rot="-2542646">
                    <a:off x="5477181" y="4771234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41" name="フリーフォーム 40">
                    <a:extLst>
                      <a:ext uri="{FF2B5EF4-FFF2-40B4-BE49-F238E27FC236}">
                        <a16:creationId xmlns:a16="http://schemas.microsoft.com/office/drawing/2014/main" id="{E5795AF4-B827-10B9-3D1B-57286700234C}"/>
                      </a:ext>
                    </a:extLst>
                  </p:cNvPr>
                  <p:cNvSpPr/>
                  <p:nvPr/>
                </p:nvSpPr>
                <p:spPr bwMode="auto">
                  <a:xfrm rot="19057354">
                    <a:off x="5477182" y="477327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50000">
                          <a:srgbClr val="0070C0"/>
                        </a:gs>
                        <a:gs pos="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chemeClr val="accent5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39" name="フリーフォーム 173">
                  <a:extLst>
                    <a:ext uri="{FF2B5EF4-FFF2-40B4-BE49-F238E27FC236}">
                      <a16:creationId xmlns:a16="http://schemas.microsoft.com/office/drawing/2014/main" id="{24749673-8B12-971C-CC86-08CA0F1706F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flipH="1">
                  <a:off x="2554579" y="6309224"/>
                  <a:ext cx="18870" cy="159877"/>
                </a:xfrm>
                <a:custGeom>
                  <a:avLst/>
                  <a:gdLst>
                    <a:gd name="T0" fmla="*/ 71 w 47834"/>
                    <a:gd name="T1" fmla="*/ 2147483647 h 32132"/>
                    <a:gd name="T2" fmla="*/ 0 w 47834"/>
                    <a:gd name="T3" fmla="*/ 0 h 32132"/>
                    <a:gd name="T4" fmla="*/ 0 60000 65536"/>
                    <a:gd name="T5" fmla="*/ 0 60000 65536"/>
                  </a:gdLst>
                  <a:ahLst/>
                  <a:cxnLst>
                    <a:cxn ang="T4">
                      <a:pos x="T0" y="T1"/>
                    </a:cxn>
                    <a:cxn ang="T5">
                      <a:pos x="T2" y="T3"/>
                    </a:cxn>
                  </a:cxnLst>
                  <a:rect l="0" t="0" r="r" b="b"/>
                  <a:pathLst>
                    <a:path w="47834" h="32132">
                      <a:moveTo>
                        <a:pt x="47834" y="31018"/>
                      </a:moveTo>
                      <a:cubicBezTo>
                        <a:pt x="40342" y="29882"/>
                        <a:pt x="59765" y="43329"/>
                        <a:pt x="0" y="0"/>
                      </a:cubicBezTo>
                    </a:path>
                  </a:pathLst>
                </a:custGeom>
                <a:noFill/>
                <a:ln w="15875" cap="flat" cmpd="sng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 anchor="ctr"/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3" name="グループ化 291">
                <a:extLst>
                  <a:ext uri="{FF2B5EF4-FFF2-40B4-BE49-F238E27FC236}">
                    <a16:creationId xmlns:a16="http://schemas.microsoft.com/office/drawing/2014/main" id="{34A1C272-84F2-E156-27B1-DE734250272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9543419">
                <a:off x="6751938" y="4922751"/>
                <a:ext cx="706406" cy="927508"/>
                <a:chOff x="1443961" y="4402964"/>
                <a:chExt cx="768461" cy="1259035"/>
              </a:xfrm>
            </p:grpSpPr>
            <p:grpSp>
              <p:nvGrpSpPr>
                <p:cNvPr id="34" name="グループ化 296">
                  <a:extLst>
                    <a:ext uri="{FF2B5EF4-FFF2-40B4-BE49-F238E27FC236}">
                      <a16:creationId xmlns:a16="http://schemas.microsoft.com/office/drawing/2014/main" id="{F31CF5F1-45B5-3EBE-5A1E-2AB63D5321BD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-2192002">
                  <a:off x="1805791" y="4402964"/>
                  <a:ext cx="406631" cy="1259035"/>
                  <a:chOff x="8189975" y="1357391"/>
                  <a:chExt cx="404371" cy="1308847"/>
                </a:xfrm>
              </p:grpSpPr>
              <p:sp>
                <p:nvSpPr>
                  <p:cNvPr id="36" name="フリーフォーム 170">
                    <a:extLst>
                      <a:ext uri="{FF2B5EF4-FFF2-40B4-BE49-F238E27FC236}">
                        <a16:creationId xmlns:a16="http://schemas.microsoft.com/office/drawing/2014/main" id="{07B102B5-FB96-955B-0A8E-4F900F969C9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T0" fmla="*/ 44824 w 404371"/>
                      <a:gd name="T1" fmla="*/ 0 h 1308847"/>
                      <a:gd name="T2" fmla="*/ 313765 w 404371"/>
                      <a:gd name="T3" fmla="*/ 394447 h 1308847"/>
                      <a:gd name="T4" fmla="*/ 403412 w 404371"/>
                      <a:gd name="T5" fmla="*/ 681318 h 1308847"/>
                      <a:gd name="T6" fmla="*/ 349624 w 404371"/>
                      <a:gd name="T7" fmla="*/ 914400 h 1308847"/>
                      <a:gd name="T8" fmla="*/ 179294 w 404371"/>
                      <a:gd name="T9" fmla="*/ 1066800 h 1308847"/>
                      <a:gd name="T10" fmla="*/ 0 w 404371"/>
                      <a:gd name="T11" fmla="*/ 1308847 h 130884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65100" cap="flat" cmpd="sng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37" name="フリーフォーム 36">
                    <a:extLst>
                      <a:ext uri="{FF2B5EF4-FFF2-40B4-BE49-F238E27FC236}">
                        <a16:creationId xmlns:a16="http://schemas.microsoft.com/office/drawing/2014/main" id="{4744D320-6C3C-FFC3-BFB8-C1BD347E36A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8189975" y="1357391"/>
                    <a:ext cx="404371" cy="1308847"/>
                  </a:xfrm>
                  <a:custGeom>
                    <a:avLst/>
                    <a:gdLst>
                      <a:gd name="connsiteX0" fmla="*/ 44824 w 404371"/>
                      <a:gd name="connsiteY0" fmla="*/ 0 h 1308847"/>
                      <a:gd name="connsiteX1" fmla="*/ 313765 w 404371"/>
                      <a:gd name="connsiteY1" fmla="*/ 394447 h 1308847"/>
                      <a:gd name="connsiteX2" fmla="*/ 403412 w 404371"/>
                      <a:gd name="connsiteY2" fmla="*/ 681318 h 1308847"/>
                      <a:gd name="connsiteX3" fmla="*/ 349624 w 404371"/>
                      <a:gd name="connsiteY3" fmla="*/ 914400 h 1308847"/>
                      <a:gd name="connsiteX4" fmla="*/ 179294 w 404371"/>
                      <a:gd name="connsiteY4" fmla="*/ 1066800 h 1308847"/>
                      <a:gd name="connsiteX5" fmla="*/ 0 w 404371"/>
                      <a:gd name="connsiteY5" fmla="*/ 1308847 h 130884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404371" h="1308847">
                        <a:moveTo>
                          <a:pt x="44824" y="0"/>
                        </a:moveTo>
                        <a:cubicBezTo>
                          <a:pt x="149412" y="140447"/>
                          <a:pt x="254000" y="280894"/>
                          <a:pt x="313765" y="394447"/>
                        </a:cubicBezTo>
                        <a:cubicBezTo>
                          <a:pt x="373530" y="508000"/>
                          <a:pt x="397436" y="594659"/>
                          <a:pt x="403412" y="681318"/>
                        </a:cubicBezTo>
                        <a:cubicBezTo>
                          <a:pt x="409388" y="767977"/>
                          <a:pt x="386977" y="850153"/>
                          <a:pt x="349624" y="914400"/>
                        </a:cubicBezTo>
                        <a:cubicBezTo>
                          <a:pt x="312271" y="978647"/>
                          <a:pt x="237565" y="1001059"/>
                          <a:pt x="179294" y="1066800"/>
                        </a:cubicBezTo>
                        <a:cubicBezTo>
                          <a:pt x="121023" y="1132541"/>
                          <a:pt x="60511" y="1220694"/>
                          <a:pt x="0" y="1308847"/>
                        </a:cubicBezTo>
                      </a:path>
                    </a:pathLst>
                  </a:custGeom>
                  <a:noFill/>
                  <a:ln w="139700" cap="flat" cmpd="sng" algn="ctr">
                    <a:gradFill flip="none" rotWithShape="1">
                      <a:gsLst>
                        <a:gs pos="0">
                          <a:srgbClr val="0070C0"/>
                        </a:gs>
                        <a:gs pos="50000">
                          <a:schemeClr val="accent1">
                            <a:lumMod val="45000"/>
                            <a:lumOff val="55000"/>
                          </a:schemeClr>
                        </a:gs>
                        <a:gs pos="100000">
                          <a:srgbClr val="0070C0"/>
                        </a:gs>
                      </a:gsLst>
                      <a:lin ang="5400000" scaled="1"/>
                      <a:tileRect/>
                    </a:gra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  <p:txBody>
                  <a:bodyPr anchor="ctr"/>
                  <a:lstStyle/>
                  <a:p>
                    <a:pPr algn="ctr">
                      <a:defRPr/>
                    </a:pPr>
                    <a:endParaRPr lang="ja-JP" altLang="en-US">
                      <a:latin typeface="Calibri" panose="020F0502020204030204" pitchFamily="34" charset="0"/>
                      <a:ea typeface="ＭＳ Ｐゴシック" panose="020B0600070205080204" pitchFamily="50" charset="-128"/>
                    </a:endParaRPr>
                  </a:p>
                </p:txBody>
              </p:sp>
            </p:grpSp>
            <p:sp>
              <p:nvSpPr>
                <p:cNvPr id="35" name="円/楕円 34">
                  <a:extLst>
                    <a:ext uri="{FF2B5EF4-FFF2-40B4-BE49-F238E27FC236}">
                      <a16:creationId xmlns:a16="http://schemas.microsoft.com/office/drawing/2014/main" id="{E092735F-FDE9-BEE6-EC0B-F832FE6E68E8}"/>
                    </a:ext>
                  </a:extLst>
                </p:cNvPr>
                <p:cNvSpPr/>
                <p:nvPr/>
              </p:nvSpPr>
              <p:spPr bwMode="auto">
                <a:xfrm>
                  <a:off x="1443961" y="4569075"/>
                  <a:ext cx="154998" cy="112452"/>
                </a:xfrm>
                <a:prstGeom prst="ellipse">
                  <a:avLst/>
                </a:prstGeom>
                <a:solidFill>
                  <a:schemeClr val="accent1"/>
                </a:solidFill>
                <a:ln w="63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scene3d>
                  <a:camera prst="orthographicFront">
                    <a:rot lat="0" lon="0" rev="15000000"/>
                  </a:camera>
                  <a:lightRig rig="threePt" dir="t"/>
                </a:scene3d>
              </p:spPr>
              <p:txBody>
                <a:bodyPr anchor="ctr"/>
                <a:lstStyle/>
                <a:p>
                  <a:pPr algn="ctr">
                    <a:defRPr/>
                  </a:pPr>
                  <a:endParaRPr lang="ja-JP" altLang="en-US">
                    <a:latin typeface="Calibri" panose="020F0502020204030204" pitchFamily="34" charset="0"/>
                    <a:ea typeface="ＭＳ Ｐゴシック" panose="020B0600070205080204" pitchFamily="50" charset="-128"/>
                  </a:endParaRPr>
                </a:p>
              </p:txBody>
            </p:sp>
          </p:grpSp>
        </p:grpSp>
        <p:sp>
          <p:nvSpPr>
            <p:cNvPr id="12" name="Text Box 659">
              <a:extLst>
                <a:ext uri="{FF2B5EF4-FFF2-40B4-BE49-F238E27FC236}">
                  <a16:creationId xmlns:a16="http://schemas.microsoft.com/office/drawing/2014/main" id="{CEE45B0D-DA64-4E07-23BE-EDE56486B4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5254" y="4975684"/>
              <a:ext cx="414399" cy="222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1265" tIns="30632" rIns="61265" bIns="30632"/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0" hangingPunct="0">
                <a:lnSpc>
                  <a:spcPct val="144000"/>
                </a:lnSpc>
              </a:pPr>
              <a:r>
                <a:rPr kumimoji="0" lang="en-US" altLang="ja-JP" sz="1200" i="1">
                  <a:solidFill>
                    <a:srgbClr val="000000"/>
                  </a:solidFill>
                  <a:latin typeface="Times New Roman" charset="0"/>
                  <a:ea typeface="ＭＳ Ｐ明朝" charset="0"/>
                  <a:cs typeface="ＭＳ Ｐ明朝" charset="0"/>
                </a:rPr>
                <a:t>E</a:t>
              </a:r>
              <a:r>
                <a:rPr kumimoji="0" lang="en-US" altLang="ja-JP" sz="1200" baseline="-25000">
                  <a:solidFill>
                    <a:srgbClr val="000000"/>
                  </a:solidFill>
                  <a:latin typeface="Times New Roman" charset="0"/>
                  <a:ea typeface="ＭＳ Ｐ明朝" charset="0"/>
                  <a:cs typeface="ＭＳ Ｐ明朝" charset="0"/>
                </a:rPr>
                <a:t>on</a:t>
              </a:r>
              <a:endParaRPr kumimoji="0" lang="ja-JP" altLang="en-US" sz="1800" baseline="-25000"/>
            </a:p>
          </p:txBody>
        </p:sp>
        <p:sp>
          <p:nvSpPr>
            <p:cNvPr id="13" name="右矢印 147">
              <a:extLst>
                <a:ext uri="{FF2B5EF4-FFF2-40B4-BE49-F238E27FC236}">
                  <a16:creationId xmlns:a16="http://schemas.microsoft.com/office/drawing/2014/main" id="{7222EC4E-C295-9C54-6229-66297C90F5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4332" y="5233230"/>
              <a:ext cx="600491" cy="166196"/>
            </a:xfrm>
            <a:prstGeom prst="rightArrow">
              <a:avLst>
                <a:gd name="adj1" fmla="val 50000"/>
                <a:gd name="adj2" fmla="val 49999"/>
              </a:avLst>
            </a:prstGeom>
            <a:noFill/>
            <a:ln w="25400">
              <a:solidFill>
                <a:srgbClr val="FFC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/>
            <a:p>
              <a:pPr algn="ctr"/>
              <a:endParaRPr lang="ja-JP" altLang="en-US">
                <a:latin typeface="Calibri" charset="0"/>
              </a:endParaRPr>
            </a:p>
          </p:txBody>
        </p:sp>
        <p:sp>
          <p:nvSpPr>
            <p:cNvPr id="14" name="Text Box 659">
              <a:extLst>
                <a:ext uri="{FF2B5EF4-FFF2-40B4-BE49-F238E27FC236}">
                  <a16:creationId xmlns:a16="http://schemas.microsoft.com/office/drawing/2014/main" id="{4591EEF9-67B1-3CE3-BA9C-9F151352CD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89889" y="4946433"/>
              <a:ext cx="414399" cy="222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1265" tIns="30632" rIns="61265" bIns="30632"/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0" hangingPunct="0">
                <a:lnSpc>
                  <a:spcPct val="144000"/>
                </a:lnSpc>
              </a:pPr>
              <a:r>
                <a:rPr kumimoji="0" lang="en-US" altLang="ja-JP" sz="1200" i="1">
                  <a:solidFill>
                    <a:srgbClr val="000000"/>
                  </a:solidFill>
                  <a:latin typeface="Times New Roman" charset="0"/>
                  <a:ea typeface="ＭＳ Ｐ明朝" charset="0"/>
                  <a:cs typeface="ＭＳ Ｐ明朝" charset="0"/>
                </a:rPr>
                <a:t>E</a:t>
              </a:r>
              <a:r>
                <a:rPr kumimoji="0" lang="en-US" altLang="ja-JP" sz="1200" baseline="-25000">
                  <a:solidFill>
                    <a:srgbClr val="000000"/>
                  </a:solidFill>
                  <a:latin typeface="Times New Roman" charset="0"/>
                  <a:ea typeface="ＭＳ Ｐ明朝" charset="0"/>
                  <a:cs typeface="ＭＳ Ｐ明朝" charset="0"/>
                </a:rPr>
                <a:t>off</a:t>
              </a:r>
              <a:endParaRPr kumimoji="0" lang="ja-JP" altLang="en-US" sz="1800" baseline="-25000"/>
            </a:p>
          </p:txBody>
        </p:sp>
        <p:sp>
          <p:nvSpPr>
            <p:cNvPr id="15" name="右矢印 149">
              <a:extLst>
                <a:ext uri="{FF2B5EF4-FFF2-40B4-BE49-F238E27FC236}">
                  <a16:creationId xmlns:a16="http://schemas.microsoft.com/office/drawing/2014/main" id="{927EE8B7-DA59-84FD-26BE-F5F19A22A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995" y="5233039"/>
              <a:ext cx="600491" cy="166196"/>
            </a:xfrm>
            <a:prstGeom prst="rightArrow">
              <a:avLst>
                <a:gd name="adj1" fmla="val 50000"/>
                <a:gd name="adj2" fmla="val 49999"/>
              </a:avLst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/>
            <a:p>
              <a:pPr algn="ctr"/>
              <a:endParaRPr lang="ja-JP" altLang="en-US">
                <a:latin typeface="Calibri" charset="0"/>
              </a:endParaRPr>
            </a:p>
          </p:txBody>
        </p:sp>
      </p:grpSp>
      <p:sp>
        <p:nvSpPr>
          <p:cNvPr id="142" name="テキスト ボックス 10">
            <a:extLst>
              <a:ext uri="{FF2B5EF4-FFF2-40B4-BE49-F238E27FC236}">
                <a16:creationId xmlns:a16="http://schemas.microsoft.com/office/drawing/2014/main" id="{B95283D2-FA43-2AE5-CB9D-6BA55B7C36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3389" y="6406205"/>
            <a:ext cx="637347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dirty="0"/>
              <a:t>A. Yoshizawa, M. </a:t>
            </a:r>
            <a:r>
              <a:rPr lang="en-US" altLang="ja-JP" sz="1400" dirty="0" err="1"/>
              <a:t>Kamiyama</a:t>
            </a:r>
            <a:r>
              <a:rPr lang="en-US" altLang="ja-JP" sz="1400" dirty="0"/>
              <a:t>, T. Hirose</a:t>
            </a:r>
            <a:r>
              <a:rPr lang="en-US" altLang="ja-JP" sz="1400" i="1" dirty="0"/>
              <a:t>, Appl. Phys. Express</a:t>
            </a:r>
            <a:r>
              <a:rPr lang="en-US" altLang="ja-JP" sz="1400" dirty="0"/>
              <a:t>, 2011, </a:t>
            </a:r>
            <a:r>
              <a:rPr lang="en-US" altLang="ja-JP" sz="1400" b="1" dirty="0"/>
              <a:t>4</a:t>
            </a:r>
            <a:r>
              <a:rPr lang="en-US" altLang="ja-JP" sz="1400" dirty="0"/>
              <a:t>, 101701.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2454870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6</Words>
  <Application>Microsoft Macintosh PowerPoint</Application>
  <PresentationFormat>ワイド画面</PresentationFormat>
  <Paragraphs>5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澤　篤</dc:creator>
  <cp:lastModifiedBy>吉澤　篤</cp:lastModifiedBy>
  <cp:revision>2</cp:revision>
  <dcterms:created xsi:type="dcterms:W3CDTF">2024-02-04T06:47:51Z</dcterms:created>
  <dcterms:modified xsi:type="dcterms:W3CDTF">2024-02-05T20:56:50Z</dcterms:modified>
</cp:coreProperties>
</file>